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56" r:id="rId2"/>
    <p:sldId id="264" r:id="rId3"/>
    <p:sldId id="262" r:id="rId4"/>
    <p:sldId id="263" r:id="rId5"/>
    <p:sldId id="265" r:id="rId6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09"/>
    <p:restoredTop sz="95788"/>
  </p:normalViewPr>
  <p:slideViewPr>
    <p:cSldViewPr snapToGrid="0" snapToObjects="1">
      <p:cViewPr varScale="1">
        <p:scale>
          <a:sx n="122" d="100"/>
          <a:sy n="122" d="100"/>
        </p:scale>
        <p:origin x="3480" y="208"/>
      </p:cViewPr>
      <p:guideLst>
        <p:guide orient="horz" pos="39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6EC9DE-0E0F-764D-9DDB-7EC8BB8D81B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696FBB-C9AF-864E-8C6E-C0ECA020CE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782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696FBB-C9AF-864E-8C6E-C0ECA020CEE9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4453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1989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2558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566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470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4041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734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4102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4576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197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7449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48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6CF03-7A7C-E441-80C6-7A06A50595BA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ABB3B-1718-9045-849A-459AAED16D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1890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13" Type="http://schemas.openxmlformats.org/officeDocument/2006/relationships/image" Target="../media/image16.jpg"/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12" Type="http://schemas.openxmlformats.org/officeDocument/2006/relationships/image" Target="../media/image15.jpg"/><Relationship Id="rId17" Type="http://schemas.openxmlformats.org/officeDocument/2006/relationships/image" Target="../media/image20.jpg"/><Relationship Id="rId2" Type="http://schemas.openxmlformats.org/officeDocument/2006/relationships/image" Target="../media/image5.jpg"/><Relationship Id="rId16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g"/><Relationship Id="rId11" Type="http://schemas.openxmlformats.org/officeDocument/2006/relationships/image" Target="../media/image14.jpg"/><Relationship Id="rId5" Type="http://schemas.openxmlformats.org/officeDocument/2006/relationships/image" Target="../media/image8.jpg"/><Relationship Id="rId15" Type="http://schemas.openxmlformats.org/officeDocument/2006/relationships/image" Target="../media/image18.jpg"/><Relationship Id="rId10" Type="http://schemas.openxmlformats.org/officeDocument/2006/relationships/image" Target="../media/image13.jpg"/><Relationship Id="rId4" Type="http://schemas.openxmlformats.org/officeDocument/2006/relationships/image" Target="../media/image7.jpg"/><Relationship Id="rId9" Type="http://schemas.openxmlformats.org/officeDocument/2006/relationships/image" Target="../media/image12.jpg"/><Relationship Id="rId14" Type="http://schemas.openxmlformats.org/officeDocument/2006/relationships/image" Target="../media/image17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g"/><Relationship Id="rId13" Type="http://schemas.openxmlformats.org/officeDocument/2006/relationships/image" Target="../media/image28.jpg"/><Relationship Id="rId3" Type="http://schemas.openxmlformats.org/officeDocument/2006/relationships/image" Target="../media/image11.jpg"/><Relationship Id="rId7" Type="http://schemas.openxmlformats.org/officeDocument/2006/relationships/image" Target="../media/image24.jpg"/><Relationship Id="rId12" Type="http://schemas.openxmlformats.org/officeDocument/2006/relationships/image" Target="../media/image27.jpg"/><Relationship Id="rId17" Type="http://schemas.openxmlformats.org/officeDocument/2006/relationships/image" Target="../media/image32.jpg"/><Relationship Id="rId2" Type="http://schemas.openxmlformats.org/officeDocument/2006/relationships/image" Target="../media/image21.jpg"/><Relationship Id="rId16" Type="http://schemas.openxmlformats.org/officeDocument/2006/relationships/image" Target="../media/image3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g"/><Relationship Id="rId11" Type="http://schemas.openxmlformats.org/officeDocument/2006/relationships/image" Target="../media/image13.jpg"/><Relationship Id="rId5" Type="http://schemas.openxmlformats.org/officeDocument/2006/relationships/image" Target="../media/image22.jpg"/><Relationship Id="rId15" Type="http://schemas.openxmlformats.org/officeDocument/2006/relationships/image" Target="../media/image30.jpg"/><Relationship Id="rId10" Type="http://schemas.openxmlformats.org/officeDocument/2006/relationships/image" Target="../media/image14.jpg"/><Relationship Id="rId4" Type="http://schemas.openxmlformats.org/officeDocument/2006/relationships/image" Target="../media/image12.jpg"/><Relationship Id="rId9" Type="http://schemas.openxmlformats.org/officeDocument/2006/relationships/image" Target="../media/image26.jpg"/><Relationship Id="rId14" Type="http://schemas.openxmlformats.org/officeDocument/2006/relationships/image" Target="../media/image29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jpg"/><Relationship Id="rId13" Type="http://schemas.openxmlformats.org/officeDocument/2006/relationships/image" Target="../media/image43.jpg"/><Relationship Id="rId18" Type="http://schemas.openxmlformats.org/officeDocument/2006/relationships/image" Target="../media/image48.jpg"/><Relationship Id="rId3" Type="http://schemas.openxmlformats.org/officeDocument/2006/relationships/image" Target="../media/image33.jpg"/><Relationship Id="rId7" Type="http://schemas.openxmlformats.org/officeDocument/2006/relationships/image" Target="../media/image37.jpg"/><Relationship Id="rId12" Type="http://schemas.openxmlformats.org/officeDocument/2006/relationships/image" Target="../media/image42.jpg"/><Relationship Id="rId17" Type="http://schemas.openxmlformats.org/officeDocument/2006/relationships/image" Target="../media/image47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6.jpg"/><Relationship Id="rId20" Type="http://schemas.openxmlformats.org/officeDocument/2006/relationships/image" Target="../media/image5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jpg"/><Relationship Id="rId11" Type="http://schemas.openxmlformats.org/officeDocument/2006/relationships/image" Target="../media/image41.jpg"/><Relationship Id="rId5" Type="http://schemas.openxmlformats.org/officeDocument/2006/relationships/image" Target="../media/image35.jpg"/><Relationship Id="rId15" Type="http://schemas.openxmlformats.org/officeDocument/2006/relationships/image" Target="../media/image45.jpg"/><Relationship Id="rId10" Type="http://schemas.openxmlformats.org/officeDocument/2006/relationships/image" Target="../media/image40.jpg"/><Relationship Id="rId19" Type="http://schemas.openxmlformats.org/officeDocument/2006/relationships/image" Target="../media/image49.jpg"/><Relationship Id="rId4" Type="http://schemas.openxmlformats.org/officeDocument/2006/relationships/image" Target="../media/image34.jpg"/><Relationship Id="rId9" Type="http://schemas.openxmlformats.org/officeDocument/2006/relationships/image" Target="../media/image39.jpg"/><Relationship Id="rId14" Type="http://schemas.openxmlformats.org/officeDocument/2006/relationships/image" Target="../media/image4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jpg"/><Relationship Id="rId2" Type="http://schemas.openxmlformats.org/officeDocument/2006/relationships/image" Target="../media/image5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4.jpg"/><Relationship Id="rId4" Type="http://schemas.openxmlformats.org/officeDocument/2006/relationships/image" Target="../media/image5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DD73037-2998-A442-9CCD-2686D458120F}"/>
              </a:ext>
            </a:extLst>
          </p:cNvPr>
          <p:cNvSpPr txBox="1"/>
          <p:nvPr/>
        </p:nvSpPr>
        <p:spPr>
          <a:xfrm>
            <a:off x="5452201" y="9595937"/>
            <a:ext cx="1388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Source data-WBs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7976AA7C-C82C-82DF-9108-9BE6B5D8579E}"/>
              </a:ext>
            </a:extLst>
          </p:cNvPr>
          <p:cNvGrpSpPr/>
          <p:nvPr/>
        </p:nvGrpSpPr>
        <p:grpSpPr>
          <a:xfrm>
            <a:off x="1741256" y="2777828"/>
            <a:ext cx="1473200" cy="2254796"/>
            <a:chOff x="890953" y="3509476"/>
            <a:chExt cx="1473200" cy="2254796"/>
          </a:xfrm>
        </p:grpSpPr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F6A53B81-2655-D740-82EC-52435CC1F2D8}"/>
                </a:ext>
              </a:extLst>
            </p:cNvPr>
            <p:cNvGrpSpPr/>
            <p:nvPr/>
          </p:nvGrpSpPr>
          <p:grpSpPr>
            <a:xfrm>
              <a:off x="890953" y="3509476"/>
              <a:ext cx="1473200" cy="1098550"/>
              <a:chOff x="890953" y="3509476"/>
              <a:chExt cx="1473200" cy="1098550"/>
            </a:xfrm>
          </p:grpSpPr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C2971B6A-00EC-B84F-A123-FD6BB32ABAAA}"/>
                  </a:ext>
                </a:extLst>
              </p:cNvPr>
              <p:cNvGrpSpPr/>
              <p:nvPr/>
            </p:nvGrpSpPr>
            <p:grpSpPr>
              <a:xfrm>
                <a:off x="890953" y="3509476"/>
                <a:ext cx="1473200" cy="1098550"/>
                <a:chOff x="890953" y="3509476"/>
                <a:chExt cx="1473200" cy="1098550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1FE47504-0371-DF41-BF40-24B99003AF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90953" y="3509476"/>
                  <a:ext cx="1473200" cy="1098550"/>
                </a:xfrm>
                <a:prstGeom prst="rect">
                  <a:avLst/>
                </a:prstGeom>
              </p:spPr>
            </p:pic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066D745E-2383-894D-9BEB-0D6F9DD0B0B9}"/>
                    </a:ext>
                  </a:extLst>
                </p:cNvPr>
                <p:cNvSpPr txBox="1"/>
                <p:nvPr/>
              </p:nvSpPr>
              <p:spPr>
                <a:xfrm>
                  <a:off x="987747" y="4071451"/>
                  <a:ext cx="4507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55 </a:t>
                  </a:r>
                  <a:r>
                    <a:rPr lang="en-GB" sz="800" dirty="0" err="1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kDa</a:t>
                  </a:r>
                  <a:endPara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43926167-E4D9-DC45-83A2-E3BDAC103418}"/>
                    </a:ext>
                  </a:extLst>
                </p:cNvPr>
                <p:cNvSpPr txBox="1"/>
                <p:nvPr/>
              </p:nvSpPr>
              <p:spPr>
                <a:xfrm>
                  <a:off x="990563" y="3992577"/>
                  <a:ext cx="4507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75 </a:t>
                  </a:r>
                  <a:r>
                    <a:rPr lang="en-GB" sz="800" dirty="0" err="1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kDa</a:t>
                  </a:r>
                  <a:endPara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4D0E3B2E-7AC4-FC4C-86DB-5CD94FBBAEFF}"/>
                    </a:ext>
                  </a:extLst>
                </p:cNvPr>
                <p:cNvSpPr txBox="1"/>
                <p:nvPr/>
              </p:nvSpPr>
              <p:spPr>
                <a:xfrm>
                  <a:off x="1716468" y="3868251"/>
                  <a:ext cx="31611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IF</a:t>
                  </a:r>
                </a:p>
              </p:txBody>
            </p:sp>
            <p:sp>
              <p:nvSpPr>
                <p:cNvPr id="61" name="Rectangle 60">
                  <a:extLst>
                    <a:ext uri="{FF2B5EF4-FFF2-40B4-BE49-F238E27FC236}">
                      <a16:creationId xmlns:a16="http://schemas.microsoft.com/office/drawing/2014/main" id="{2A9D97DB-2C45-514F-84BA-06061A2DFC42}"/>
                    </a:ext>
                  </a:extLst>
                </p:cNvPr>
                <p:cNvSpPr/>
                <p:nvPr/>
              </p:nvSpPr>
              <p:spPr>
                <a:xfrm>
                  <a:off x="1412024" y="4082608"/>
                  <a:ext cx="189956" cy="85080"/>
                </a:xfrm>
                <a:prstGeom prst="rect">
                  <a:avLst/>
                </a:prstGeom>
                <a:noFill/>
                <a:ln w="3175">
                  <a:solidFill>
                    <a:srgbClr val="FF00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38AEDA1-F19D-C547-BDE6-BDA72C431358}"/>
                  </a:ext>
                </a:extLst>
              </p:cNvPr>
              <p:cNvSpPr txBox="1"/>
              <p:nvPr/>
            </p:nvSpPr>
            <p:spPr>
              <a:xfrm>
                <a:off x="1330870" y="3930479"/>
                <a:ext cx="25840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 err="1">
                    <a:latin typeface="Arial Narrow" panose="020B0604020202020204" pitchFamily="34" charset="0"/>
                    <a:cs typeface="Arial Narrow" panose="020B0604020202020204" pitchFamily="34" charset="0"/>
                  </a:rPr>
                  <a:t>wt</a:t>
                </a:r>
                <a:endParaRPr lang="en-GB" sz="700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B4D7944B-EFCF-BB42-898C-F855C6F1CB85}"/>
                  </a:ext>
                </a:extLst>
              </p:cNvPr>
              <p:cNvSpPr txBox="1"/>
              <p:nvPr/>
            </p:nvSpPr>
            <p:spPr>
              <a:xfrm>
                <a:off x="1417447" y="3930479"/>
                <a:ext cx="27924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 err="1">
                    <a:latin typeface="Arial Narrow" panose="020B0604020202020204" pitchFamily="34" charset="0"/>
                    <a:cs typeface="Arial Narrow" panose="020B0604020202020204" pitchFamily="34" charset="0"/>
                  </a:rPr>
                  <a:t>Hq</a:t>
                </a:r>
                <a:endParaRPr lang="en-GB" sz="700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0E868703-C8FC-9146-9D97-9DCBA972280A}"/>
                </a:ext>
              </a:extLst>
            </p:cNvPr>
            <p:cNvGrpSpPr/>
            <p:nvPr/>
          </p:nvGrpSpPr>
          <p:grpSpPr>
            <a:xfrm>
              <a:off x="890953" y="4665722"/>
              <a:ext cx="1473200" cy="1098550"/>
              <a:chOff x="890953" y="4665722"/>
              <a:chExt cx="1473200" cy="1098550"/>
            </a:xfrm>
          </p:grpSpPr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6EE65128-68FA-FC42-9368-1FC3001ADA54}"/>
                  </a:ext>
                </a:extLst>
              </p:cNvPr>
              <p:cNvGrpSpPr/>
              <p:nvPr/>
            </p:nvGrpSpPr>
            <p:grpSpPr>
              <a:xfrm>
                <a:off x="890953" y="4665722"/>
                <a:ext cx="1473200" cy="1098550"/>
                <a:chOff x="890953" y="4665722"/>
                <a:chExt cx="1473200" cy="1098550"/>
              </a:xfrm>
            </p:grpSpPr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43162952-6043-8A48-964A-980A27CBA4E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890953" y="4665722"/>
                  <a:ext cx="1473200" cy="1098550"/>
                </a:xfrm>
                <a:prstGeom prst="rect">
                  <a:avLst/>
                </a:prstGeom>
              </p:spPr>
            </p:pic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60A183BF-D55F-3749-A662-0217BB05A688}"/>
                    </a:ext>
                  </a:extLst>
                </p:cNvPr>
                <p:cNvSpPr txBox="1"/>
                <p:nvPr/>
              </p:nvSpPr>
              <p:spPr>
                <a:xfrm>
                  <a:off x="952892" y="5170001"/>
                  <a:ext cx="4507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55 </a:t>
                  </a:r>
                  <a:r>
                    <a:rPr lang="en-GB" sz="800" dirty="0" err="1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kDa</a:t>
                  </a:r>
                  <a:endPara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E7826E54-A310-7444-AFC5-0057C513626F}"/>
                    </a:ext>
                  </a:extLst>
                </p:cNvPr>
                <p:cNvSpPr txBox="1"/>
                <p:nvPr/>
              </p:nvSpPr>
              <p:spPr>
                <a:xfrm>
                  <a:off x="955708" y="5091127"/>
                  <a:ext cx="4507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75 </a:t>
                  </a:r>
                  <a:r>
                    <a:rPr lang="en-GB" sz="800" dirty="0" err="1">
                      <a:solidFill>
                        <a:schemeClr val="bg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kDa</a:t>
                  </a:r>
                  <a:endPara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B021A229-92CE-3B4A-A58A-05D4D495ED95}"/>
                    </a:ext>
                  </a:extLst>
                </p:cNvPr>
                <p:cNvSpPr txBox="1"/>
                <p:nvPr/>
              </p:nvSpPr>
              <p:spPr>
                <a:xfrm>
                  <a:off x="1573593" y="5004102"/>
                  <a:ext cx="43313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tubulin</a:t>
                  </a:r>
                </a:p>
              </p:txBody>
            </p:sp>
            <p:sp>
              <p:nvSpPr>
                <p:cNvPr id="60" name="Rectangle 59">
                  <a:extLst>
                    <a:ext uri="{FF2B5EF4-FFF2-40B4-BE49-F238E27FC236}">
                      <a16:creationId xmlns:a16="http://schemas.microsoft.com/office/drawing/2014/main" id="{407FE51C-6C17-9A44-9FA5-6414B570F0A4}"/>
                    </a:ext>
                  </a:extLst>
                </p:cNvPr>
                <p:cNvSpPr/>
                <p:nvPr/>
              </p:nvSpPr>
              <p:spPr>
                <a:xfrm>
                  <a:off x="1383637" y="5254578"/>
                  <a:ext cx="189956" cy="85080"/>
                </a:xfrm>
                <a:prstGeom prst="rect">
                  <a:avLst/>
                </a:prstGeom>
                <a:noFill/>
                <a:ln w="3175">
                  <a:solidFill>
                    <a:srgbClr val="FF00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8F032755-3B2D-8D4E-AAC7-F5AF762C0C3C}"/>
                  </a:ext>
                </a:extLst>
              </p:cNvPr>
              <p:cNvSpPr txBox="1"/>
              <p:nvPr/>
            </p:nvSpPr>
            <p:spPr>
              <a:xfrm>
                <a:off x="1290257" y="5077187"/>
                <a:ext cx="25840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 err="1">
                    <a:latin typeface="Arial Narrow" panose="020B0604020202020204" pitchFamily="34" charset="0"/>
                    <a:cs typeface="Arial Narrow" panose="020B0604020202020204" pitchFamily="34" charset="0"/>
                  </a:rPr>
                  <a:t>wt</a:t>
                </a:r>
                <a:endParaRPr lang="en-GB" sz="700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B34F4FC8-0C16-ED40-AA42-7D0E910BE14B}"/>
                  </a:ext>
                </a:extLst>
              </p:cNvPr>
              <p:cNvSpPr txBox="1"/>
              <p:nvPr/>
            </p:nvSpPr>
            <p:spPr>
              <a:xfrm>
                <a:off x="1376834" y="5077187"/>
                <a:ext cx="27924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 err="1">
                    <a:latin typeface="Arial Narrow" panose="020B0604020202020204" pitchFamily="34" charset="0"/>
                    <a:cs typeface="Arial Narrow" panose="020B0604020202020204" pitchFamily="34" charset="0"/>
                  </a:rPr>
                  <a:t>Hq</a:t>
                </a:r>
                <a:endParaRPr lang="en-GB" sz="700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</p:grp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27371870-8289-C25A-E5DA-F318C9BB1C22}"/>
              </a:ext>
            </a:extLst>
          </p:cNvPr>
          <p:cNvSpPr txBox="1"/>
          <p:nvPr/>
        </p:nvSpPr>
        <p:spPr>
          <a:xfrm>
            <a:off x="6184" y="230455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1D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EA76E076-E161-6723-A65D-6603006DCBBD}"/>
              </a:ext>
            </a:extLst>
          </p:cNvPr>
          <p:cNvGrpSpPr/>
          <p:nvPr/>
        </p:nvGrpSpPr>
        <p:grpSpPr>
          <a:xfrm>
            <a:off x="96953" y="2631558"/>
            <a:ext cx="761691" cy="546547"/>
            <a:chOff x="3236236" y="3152926"/>
            <a:chExt cx="794946" cy="570408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9FBCBD21-4680-9187-086A-4CE2A939DD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3619" t="52155" r="51470" b="39190"/>
            <a:stretch/>
          </p:blipFill>
          <p:spPr>
            <a:xfrm>
              <a:off x="3573166" y="3306785"/>
              <a:ext cx="439313" cy="19015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7E7BBE6A-6FB2-FF29-2833-6A08179C83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601" t="53008" r="53460" b="38225"/>
            <a:stretch/>
          </p:blipFill>
          <p:spPr>
            <a:xfrm>
              <a:off x="3572296" y="3513375"/>
              <a:ext cx="440183" cy="19262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01802B7-BF8A-4126-811C-47C4ADB9AFA6}"/>
                </a:ext>
              </a:extLst>
            </p:cNvPr>
            <p:cNvSpPr txBox="1"/>
            <p:nvPr/>
          </p:nvSpPr>
          <p:spPr>
            <a:xfrm>
              <a:off x="3344979" y="3304069"/>
              <a:ext cx="313185" cy="2087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IF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9227348E-4436-692A-B873-3B2AEF99AB32}"/>
                </a:ext>
              </a:extLst>
            </p:cNvPr>
            <p:cNvSpPr txBox="1"/>
            <p:nvPr/>
          </p:nvSpPr>
          <p:spPr>
            <a:xfrm>
              <a:off x="3236236" y="3514545"/>
              <a:ext cx="421929" cy="2087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tubulin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85F5998B-B545-01E7-82F9-553377EC6206}"/>
                </a:ext>
              </a:extLst>
            </p:cNvPr>
            <p:cNvSpPr txBox="1"/>
            <p:nvPr/>
          </p:nvSpPr>
          <p:spPr>
            <a:xfrm>
              <a:off x="3584676" y="3153242"/>
              <a:ext cx="269686" cy="2087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wt</a:t>
              </a:r>
              <a:endParaRPr lang="en-US" sz="7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AA2C8B2-7F83-F235-A3E8-5DFD162E545D}"/>
                </a:ext>
              </a:extLst>
            </p:cNvPr>
            <p:cNvSpPr txBox="1"/>
            <p:nvPr/>
          </p:nvSpPr>
          <p:spPr>
            <a:xfrm>
              <a:off x="3739746" y="3152926"/>
              <a:ext cx="291436" cy="2087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Hq</a:t>
              </a:r>
              <a:endParaRPr lang="en-US" sz="7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1B2361C-3549-C54D-DD90-612C44296E34}"/>
              </a:ext>
            </a:extLst>
          </p:cNvPr>
          <p:cNvSpPr txBox="1"/>
          <p:nvPr/>
        </p:nvSpPr>
        <p:spPr>
          <a:xfrm>
            <a:off x="54913" y="420414"/>
            <a:ext cx="6743770" cy="8901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tochondrial Complex I inhibition enhances astrocyte responsiveness to pro-inflammatory stimuli</a:t>
            </a:r>
            <a:endParaRPr lang="en-D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na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schhof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mal John Mathew, Lorenzo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nagu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c Beyer, Dan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hninge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erluigi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coter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niele Bano</a:t>
            </a:r>
            <a:endParaRPr lang="en-D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782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DD73037-2998-A442-9CCD-2686D458120F}"/>
              </a:ext>
            </a:extLst>
          </p:cNvPr>
          <p:cNvSpPr txBox="1"/>
          <p:nvPr/>
        </p:nvSpPr>
        <p:spPr>
          <a:xfrm>
            <a:off x="5452201" y="9595937"/>
            <a:ext cx="1388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Source data-WB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371870-8289-C25A-E5DA-F318C9BB1C22}"/>
              </a:ext>
            </a:extLst>
          </p:cNvPr>
          <p:cNvSpPr txBox="1"/>
          <p:nvPr/>
        </p:nvSpPr>
        <p:spPr>
          <a:xfrm>
            <a:off x="10191" y="14994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2B</a:t>
            </a:r>
          </a:p>
        </p:txBody>
      </p: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81B933DF-24E4-D851-747F-ABE04AA3185B}"/>
              </a:ext>
            </a:extLst>
          </p:cNvPr>
          <p:cNvGrpSpPr/>
          <p:nvPr/>
        </p:nvGrpSpPr>
        <p:grpSpPr>
          <a:xfrm>
            <a:off x="106936" y="417283"/>
            <a:ext cx="1037838" cy="2423204"/>
            <a:chOff x="4581080" y="96448"/>
            <a:chExt cx="1037838" cy="2423204"/>
          </a:xfrm>
        </p:grpSpPr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1CAF6330-946F-CBD8-228A-61E37332943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581080" y="96448"/>
              <a:ext cx="1037838" cy="2423204"/>
              <a:chOff x="819612" y="2576804"/>
              <a:chExt cx="1062093" cy="2479840"/>
            </a:xfrm>
          </p:grpSpPr>
          <p:grpSp>
            <p:nvGrpSpPr>
              <p:cNvPr id="115" name="Group 114">
                <a:extLst>
                  <a:ext uri="{FF2B5EF4-FFF2-40B4-BE49-F238E27FC236}">
                    <a16:creationId xmlns:a16="http://schemas.microsoft.com/office/drawing/2014/main" id="{0609F14E-E511-7375-D6CA-3EC39BBEBCF5}"/>
                  </a:ext>
                </a:extLst>
              </p:cNvPr>
              <p:cNvGrpSpPr/>
              <p:nvPr/>
            </p:nvGrpSpPr>
            <p:grpSpPr>
              <a:xfrm>
                <a:off x="953227" y="2576804"/>
                <a:ext cx="928478" cy="716300"/>
                <a:chOff x="417094" y="2604929"/>
                <a:chExt cx="928478" cy="716300"/>
              </a:xfrm>
            </p:grpSpPr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078EDD02-18F4-4FE4-97BB-0A8AF5CE8D8C}"/>
                    </a:ext>
                  </a:extLst>
                </p:cNvPr>
                <p:cNvSpPr txBox="1"/>
                <p:nvPr/>
              </p:nvSpPr>
              <p:spPr>
                <a:xfrm>
                  <a:off x="472057" y="2847947"/>
                  <a:ext cx="31611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IF</a:t>
                  </a:r>
                </a:p>
              </p:txBody>
            </p:sp>
            <p:sp>
              <p:nvSpPr>
                <p:cNvPr id="132" name="TextBox 131">
                  <a:extLst>
                    <a:ext uri="{FF2B5EF4-FFF2-40B4-BE49-F238E27FC236}">
                      <a16:creationId xmlns:a16="http://schemas.microsoft.com/office/drawing/2014/main" id="{57DDDCAC-47C3-5EB2-D4FE-C8C8417890FD}"/>
                    </a:ext>
                  </a:extLst>
                </p:cNvPr>
                <p:cNvSpPr txBox="1"/>
                <p:nvPr/>
              </p:nvSpPr>
              <p:spPr>
                <a:xfrm>
                  <a:off x="417094" y="3100751"/>
                  <a:ext cx="371074" cy="220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ctin</a:t>
                  </a:r>
                </a:p>
              </p:txBody>
            </p:sp>
            <p:sp>
              <p:nvSpPr>
                <p:cNvPr id="133" name="TextBox 132">
                  <a:extLst>
                    <a:ext uri="{FF2B5EF4-FFF2-40B4-BE49-F238E27FC236}">
                      <a16:creationId xmlns:a16="http://schemas.microsoft.com/office/drawing/2014/main" id="{45372BC5-1C04-502D-FDF9-D959549794BC}"/>
                    </a:ext>
                  </a:extLst>
                </p:cNvPr>
                <p:cNvSpPr txBox="1"/>
                <p:nvPr/>
              </p:nvSpPr>
              <p:spPr>
                <a:xfrm rot="19220584">
                  <a:off x="677979" y="2604929"/>
                  <a:ext cx="495750" cy="2047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cramble</a:t>
                  </a:r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BA6DBDEA-EBB4-8F96-5761-758A4363A61B}"/>
                    </a:ext>
                  </a:extLst>
                </p:cNvPr>
                <p:cNvSpPr txBox="1"/>
                <p:nvPr/>
              </p:nvSpPr>
              <p:spPr>
                <a:xfrm rot="19220584">
                  <a:off x="908879" y="2625680"/>
                  <a:ext cx="436693" cy="2047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700" i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iAifm1</a:t>
                  </a:r>
                </a:p>
              </p:txBody>
            </p:sp>
          </p:grpSp>
          <p:pic>
            <p:nvPicPr>
              <p:cNvPr id="116" name="Picture 115">
                <a:extLst>
                  <a:ext uri="{FF2B5EF4-FFF2-40B4-BE49-F238E27FC236}">
                    <a16:creationId xmlns:a16="http://schemas.microsoft.com/office/drawing/2014/main" id="{12AB99FB-503D-F60F-CF19-E91D6A0305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70554" t="21737" r="15138" b="69812"/>
              <a:stretch/>
            </p:blipFill>
            <p:spPr>
              <a:xfrm>
                <a:off x="1246603" y="3329218"/>
                <a:ext cx="463728" cy="204245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17" name="Picture 116">
                <a:extLst>
                  <a:ext uri="{FF2B5EF4-FFF2-40B4-BE49-F238E27FC236}">
                    <a16:creationId xmlns:a16="http://schemas.microsoft.com/office/drawing/2014/main" id="{938A0342-9AFE-B2D9-8E63-CFB41F589A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0145" t="25995" r="15546" b="55993"/>
              <a:stretch/>
            </p:blipFill>
            <p:spPr>
              <a:xfrm>
                <a:off x="1246603" y="3544721"/>
                <a:ext cx="463761" cy="435316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id="{5710E7A0-EE5E-C976-F370-08DFDEAC7E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3191" t="38970" r="12531" b="54694"/>
              <a:stretch/>
            </p:blipFill>
            <p:spPr>
              <a:xfrm>
                <a:off x="1246603" y="3995984"/>
                <a:ext cx="462781" cy="15311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19" name="Picture 118">
                <a:extLst>
                  <a:ext uri="{FF2B5EF4-FFF2-40B4-BE49-F238E27FC236}">
                    <a16:creationId xmlns:a16="http://schemas.microsoft.com/office/drawing/2014/main" id="{812CA002-CD2A-5541-C79B-2F5C1EB42E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49279" t="39062" r="40332" b="53111"/>
              <a:stretch/>
            </p:blipFill>
            <p:spPr>
              <a:xfrm>
                <a:off x="1246602" y="4541792"/>
                <a:ext cx="464400" cy="260893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20" name="Picture 119">
                <a:extLst>
                  <a:ext uri="{FF2B5EF4-FFF2-40B4-BE49-F238E27FC236}">
                    <a16:creationId xmlns:a16="http://schemas.microsoft.com/office/drawing/2014/main" id="{DC1C70F5-17E1-FBB2-52DB-5DF9B79101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7857" t="46413" r="29053" b="46971"/>
              <a:stretch/>
            </p:blipFill>
            <p:spPr>
              <a:xfrm>
                <a:off x="1246603" y="4168202"/>
                <a:ext cx="462781" cy="17443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21" name="Picture 120">
                <a:extLst>
                  <a:ext uri="{FF2B5EF4-FFF2-40B4-BE49-F238E27FC236}">
                    <a16:creationId xmlns:a16="http://schemas.microsoft.com/office/drawing/2014/main" id="{20E277A2-A246-DB89-142E-EE7E09E2A0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61195" t="39999" r="25716" b="53931"/>
              <a:stretch/>
            </p:blipFill>
            <p:spPr>
              <a:xfrm>
                <a:off x="1246603" y="4363165"/>
                <a:ext cx="462781" cy="160031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B01C01A5-9C2D-98AD-12A1-4CFD8845E1A7}"/>
                  </a:ext>
                </a:extLst>
              </p:cNvPr>
              <p:cNvSpPr txBox="1"/>
              <p:nvPr/>
            </p:nvSpPr>
            <p:spPr>
              <a:xfrm>
                <a:off x="1041589" y="3968200"/>
                <a:ext cx="27924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H3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91A6BA69-A4BA-9611-BEC5-6F0156B03C60}"/>
                  </a:ext>
                </a:extLst>
              </p:cNvPr>
              <p:cNvSpPr txBox="1"/>
              <p:nvPr/>
            </p:nvSpPr>
            <p:spPr>
              <a:xfrm>
                <a:off x="1039541" y="4329087"/>
                <a:ext cx="27924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H3</a:t>
                </a:r>
              </a:p>
            </p:txBody>
          </p:sp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584794A7-3D8B-CFAD-D784-08C1ED35D5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0895" t="28688" r="37698" b="63424"/>
              <a:stretch/>
            </p:blipFill>
            <p:spPr>
              <a:xfrm>
                <a:off x="1246602" y="4817178"/>
                <a:ext cx="464400" cy="239466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311601C6-ED31-2E0B-4838-F3EC8574CD39}"/>
                  </a:ext>
                </a:extLst>
              </p:cNvPr>
              <p:cNvSpPr txBox="1"/>
              <p:nvPr/>
            </p:nvSpPr>
            <p:spPr>
              <a:xfrm>
                <a:off x="894954" y="3286498"/>
                <a:ext cx="42030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TP5A</a:t>
                </a:r>
              </a:p>
              <a:p>
                <a:pPr algn="r"/>
                <a:r>
                  <a:rPr lang="en-US" sz="6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(CV)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F46602C0-232E-1735-4B37-1B1D3A5ABC52}"/>
                  </a:ext>
                </a:extLst>
              </p:cNvPr>
              <p:cNvSpPr txBox="1"/>
              <p:nvPr/>
            </p:nvSpPr>
            <p:spPr>
              <a:xfrm>
                <a:off x="819612" y="3506357"/>
                <a:ext cx="49564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UQCRC2</a:t>
                </a:r>
              </a:p>
              <a:p>
                <a:pPr algn="r"/>
                <a:r>
                  <a:rPr lang="en-US" sz="6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(CIII)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FAEE4D94-8887-2FF0-7C20-EEBD812BE8F9}"/>
                  </a:ext>
                </a:extLst>
              </p:cNvPr>
              <p:cNvSpPr txBox="1"/>
              <p:nvPr/>
            </p:nvSpPr>
            <p:spPr>
              <a:xfrm>
                <a:off x="928246" y="3745240"/>
                <a:ext cx="38985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DHB</a:t>
                </a:r>
              </a:p>
              <a:p>
                <a:pPr algn="r"/>
                <a:r>
                  <a:rPr lang="en-US" sz="6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(CII)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6C6052E6-B4FB-6F2B-093C-F3C4A82F22AB}"/>
                  </a:ext>
                </a:extLst>
              </p:cNvPr>
              <p:cNvSpPr txBox="1"/>
              <p:nvPr/>
            </p:nvSpPr>
            <p:spPr>
              <a:xfrm>
                <a:off x="835643" y="4097806"/>
                <a:ext cx="47961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NDUFB8</a:t>
                </a:r>
              </a:p>
              <a:p>
                <a:pPr algn="r"/>
                <a:r>
                  <a:rPr lang="en-US" sz="6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(CI)</a:t>
                </a: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52A97D73-4F67-CC84-1DB7-E637E36963BA}"/>
                  </a:ext>
                </a:extLst>
              </p:cNvPr>
              <p:cNvSpPr txBox="1"/>
              <p:nvPr/>
            </p:nvSpPr>
            <p:spPr>
              <a:xfrm>
                <a:off x="982541" y="4833428"/>
                <a:ext cx="34176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ctin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BCAABE2A-231E-1423-E5DE-49A736BE7D6E}"/>
                  </a:ext>
                </a:extLst>
              </p:cNvPr>
              <p:cNvSpPr txBox="1"/>
              <p:nvPr/>
            </p:nvSpPr>
            <p:spPr>
              <a:xfrm>
                <a:off x="857508" y="4507153"/>
                <a:ext cx="466794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MT-CO1</a:t>
                </a:r>
              </a:p>
              <a:p>
                <a:pPr algn="r"/>
                <a:r>
                  <a:rPr lang="en-US" sz="6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(CIV)</a:t>
                </a:r>
              </a:p>
            </p:txBody>
          </p:sp>
        </p:grpSp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D5E4F156-ACBB-8BF1-8045-39B60085F4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4186" t="36062" r="32602" b="55399"/>
            <a:stretch/>
          </p:blipFill>
          <p:spPr>
            <a:xfrm>
              <a:off x="4996680" y="327914"/>
              <a:ext cx="453600" cy="21864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id="{EE3A6C92-5AD4-0F07-CA06-7ABBF91137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5113" t="45924" r="32143" b="44482"/>
            <a:stretch/>
          </p:blipFill>
          <p:spPr>
            <a:xfrm>
              <a:off x="4999275" y="555805"/>
              <a:ext cx="453600" cy="25462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B9C06D51-8373-363B-6755-844D24BAE011}"/>
              </a:ext>
            </a:extLst>
          </p:cNvPr>
          <p:cNvGrpSpPr/>
          <p:nvPr/>
        </p:nvGrpSpPr>
        <p:grpSpPr>
          <a:xfrm>
            <a:off x="1751371" y="642398"/>
            <a:ext cx="1473200" cy="1098550"/>
            <a:chOff x="1268047" y="3251441"/>
            <a:chExt cx="1473200" cy="1098550"/>
          </a:xfrm>
        </p:grpSpPr>
        <p:pic>
          <p:nvPicPr>
            <p:cNvPr id="146" name="Picture 145">
              <a:extLst>
                <a:ext uri="{FF2B5EF4-FFF2-40B4-BE49-F238E27FC236}">
                  <a16:creationId xmlns:a16="http://schemas.microsoft.com/office/drawing/2014/main" id="{CAE9CE20-EEA8-9D92-79DA-F30318B193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68047" y="3251441"/>
              <a:ext cx="1473200" cy="1098550"/>
            </a:xfrm>
            <a:prstGeom prst="rect">
              <a:avLst/>
            </a:prstGeom>
          </p:spPr>
        </p:pic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86E1A25E-0B13-B455-33B9-1AFE92D1FA4C}"/>
                </a:ext>
              </a:extLst>
            </p:cNvPr>
            <p:cNvSpPr txBox="1"/>
            <p:nvPr/>
          </p:nvSpPr>
          <p:spPr>
            <a:xfrm>
              <a:off x="1474392" y="362883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0E52228F-47C7-1239-95DB-58C1169D1AD0}"/>
                </a:ext>
              </a:extLst>
            </p:cNvPr>
            <p:cNvSpPr txBox="1"/>
            <p:nvPr/>
          </p:nvSpPr>
          <p:spPr>
            <a:xfrm>
              <a:off x="1474392" y="378418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B73D172F-021E-5E15-D015-9E1730C170F5}"/>
                </a:ext>
              </a:extLst>
            </p:cNvPr>
            <p:cNvSpPr txBox="1"/>
            <p:nvPr/>
          </p:nvSpPr>
          <p:spPr>
            <a:xfrm>
              <a:off x="1474392" y="354063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FB70753A-DCE3-FB36-8CC3-F6DD328924EC}"/>
                </a:ext>
              </a:extLst>
            </p:cNvPr>
            <p:cNvSpPr txBox="1"/>
            <p:nvPr/>
          </p:nvSpPr>
          <p:spPr>
            <a:xfrm>
              <a:off x="2016105" y="3800716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IF</a:t>
              </a:r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BA7991EC-D5E1-6FBC-EB63-B82883575FE4}"/>
                </a:ext>
              </a:extLst>
            </p:cNvPr>
            <p:cNvSpPr/>
            <p:nvPr/>
          </p:nvSpPr>
          <p:spPr>
            <a:xfrm>
              <a:off x="2062565" y="3644786"/>
              <a:ext cx="197322" cy="7313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C0F8A681-E023-4A17-F7CE-3A34A9B126BA}"/>
                </a:ext>
              </a:extLst>
            </p:cNvPr>
            <p:cNvSpPr txBox="1"/>
            <p:nvPr/>
          </p:nvSpPr>
          <p:spPr>
            <a:xfrm rot="19358159">
              <a:off x="1971033" y="3414521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7B41D198-523F-C8FE-47A9-E016E494838F}"/>
                </a:ext>
              </a:extLst>
            </p:cNvPr>
            <p:cNvSpPr txBox="1"/>
            <p:nvPr/>
          </p:nvSpPr>
          <p:spPr>
            <a:xfrm rot="19358159">
              <a:off x="2084760" y="3443885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</p:grp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2280D2F4-0C6C-5D1F-9F86-BF497EE48BC8}"/>
              </a:ext>
            </a:extLst>
          </p:cNvPr>
          <p:cNvGrpSpPr/>
          <p:nvPr/>
        </p:nvGrpSpPr>
        <p:grpSpPr>
          <a:xfrm>
            <a:off x="1731833" y="1820564"/>
            <a:ext cx="1473200" cy="1098550"/>
            <a:chOff x="1248509" y="4429607"/>
            <a:chExt cx="1473200" cy="1098550"/>
          </a:xfrm>
        </p:grpSpPr>
        <p:pic>
          <p:nvPicPr>
            <p:cNvPr id="155" name="Picture 154">
              <a:extLst>
                <a:ext uri="{FF2B5EF4-FFF2-40B4-BE49-F238E27FC236}">
                  <a16:creationId xmlns:a16="http://schemas.microsoft.com/office/drawing/2014/main" id="{2F7F2FE7-14ED-9D91-1B2D-C1680FDDAE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248509" y="4429607"/>
              <a:ext cx="1473200" cy="1098550"/>
            </a:xfrm>
            <a:prstGeom prst="rect">
              <a:avLst/>
            </a:prstGeom>
          </p:spPr>
        </p:pic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87813210-B3D9-6B8E-8778-E3DD0C1C7DD7}"/>
                </a:ext>
              </a:extLst>
            </p:cNvPr>
            <p:cNvSpPr txBox="1"/>
            <p:nvPr/>
          </p:nvSpPr>
          <p:spPr>
            <a:xfrm>
              <a:off x="1474392" y="480138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ECCFFB26-C8CD-EDD9-356E-269D95E1E376}"/>
                </a:ext>
              </a:extLst>
            </p:cNvPr>
            <p:cNvSpPr txBox="1"/>
            <p:nvPr/>
          </p:nvSpPr>
          <p:spPr>
            <a:xfrm>
              <a:off x="1474392" y="4956727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990C1D0E-30A2-3FDF-E5BD-A57EA05537BC}"/>
                </a:ext>
              </a:extLst>
            </p:cNvPr>
            <p:cNvSpPr txBox="1"/>
            <p:nvPr/>
          </p:nvSpPr>
          <p:spPr>
            <a:xfrm>
              <a:off x="1474392" y="471318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B72D424E-7449-B628-603D-EF4213C68564}"/>
                </a:ext>
              </a:extLst>
            </p:cNvPr>
            <p:cNvSpPr txBox="1"/>
            <p:nvPr/>
          </p:nvSpPr>
          <p:spPr>
            <a:xfrm>
              <a:off x="1976401" y="4952570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27763D4B-352E-A9F8-8A5C-5CC095C87F8B}"/>
                </a:ext>
              </a:extLst>
            </p:cNvPr>
            <p:cNvSpPr/>
            <p:nvPr/>
          </p:nvSpPr>
          <p:spPr>
            <a:xfrm>
              <a:off x="2057292" y="4945568"/>
              <a:ext cx="197322" cy="7313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79ED0EC0-D164-4FC4-789B-097F79F0659D}"/>
                </a:ext>
              </a:extLst>
            </p:cNvPr>
            <p:cNvSpPr txBox="1"/>
            <p:nvPr/>
          </p:nvSpPr>
          <p:spPr>
            <a:xfrm rot="19358159">
              <a:off x="1965760" y="471530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69E471C-A7A1-1DC9-A36A-DC5BD243F257}"/>
                </a:ext>
              </a:extLst>
            </p:cNvPr>
            <p:cNvSpPr txBox="1"/>
            <p:nvPr/>
          </p:nvSpPr>
          <p:spPr>
            <a:xfrm rot="19358159">
              <a:off x="2079487" y="4744667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</p:grpSp>
      <p:sp>
        <p:nvSpPr>
          <p:cNvPr id="163" name="TextBox 162">
            <a:extLst>
              <a:ext uri="{FF2B5EF4-FFF2-40B4-BE49-F238E27FC236}">
                <a16:creationId xmlns:a16="http://schemas.microsoft.com/office/drawing/2014/main" id="{E076094F-C0E0-829B-607E-B5CB30A76B31}"/>
              </a:ext>
            </a:extLst>
          </p:cNvPr>
          <p:cNvSpPr txBox="1"/>
          <p:nvPr/>
        </p:nvSpPr>
        <p:spPr>
          <a:xfrm rot="19358159">
            <a:off x="2948911" y="4485227"/>
            <a:ext cx="4844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 Narrow" panose="020B0604020202020204" pitchFamily="34" charset="0"/>
                <a:cs typeface="Arial Narrow" panose="020B0604020202020204" pitchFamily="34" charset="0"/>
              </a:rPr>
              <a:t>scramble</a:t>
            </a:r>
          </a:p>
        </p:txBody>
      </p:sp>
      <p:grpSp>
        <p:nvGrpSpPr>
          <p:cNvPr id="164" name="Group 163">
            <a:extLst>
              <a:ext uri="{FF2B5EF4-FFF2-40B4-BE49-F238E27FC236}">
                <a16:creationId xmlns:a16="http://schemas.microsoft.com/office/drawing/2014/main" id="{93617049-D6C9-BDD5-5394-A2BCC4510563}"/>
              </a:ext>
            </a:extLst>
          </p:cNvPr>
          <p:cNvGrpSpPr/>
          <p:nvPr/>
        </p:nvGrpSpPr>
        <p:grpSpPr>
          <a:xfrm>
            <a:off x="1624389" y="4439643"/>
            <a:ext cx="1864969" cy="1098550"/>
            <a:chOff x="2815616" y="4429607"/>
            <a:chExt cx="1864969" cy="1098550"/>
          </a:xfrm>
        </p:grpSpPr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C38946E5-33F6-4CCF-79C1-06D2DD69BD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187655" y="4429607"/>
              <a:ext cx="1473200" cy="1098550"/>
            </a:xfrm>
            <a:prstGeom prst="rect">
              <a:avLst/>
            </a:prstGeom>
          </p:spPr>
        </p:pic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4BD0419F-63B6-8499-6311-806F1B73DEFE}"/>
                </a:ext>
              </a:extLst>
            </p:cNvPr>
            <p:cNvSpPr/>
            <p:nvPr/>
          </p:nvSpPr>
          <p:spPr>
            <a:xfrm>
              <a:off x="4225925" y="4743034"/>
              <a:ext cx="209550" cy="209536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1D710EA3-E1EC-1A8F-E284-1EC8D31C86D4}"/>
                </a:ext>
              </a:extLst>
            </p:cNvPr>
            <p:cNvSpPr txBox="1"/>
            <p:nvPr/>
          </p:nvSpPr>
          <p:spPr>
            <a:xfrm>
              <a:off x="2815616" y="453322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09A7BF6F-4CD9-D261-5E33-E3011F1143FE}"/>
                </a:ext>
              </a:extLst>
            </p:cNvPr>
            <p:cNvSpPr txBox="1"/>
            <p:nvPr/>
          </p:nvSpPr>
          <p:spPr>
            <a:xfrm>
              <a:off x="2815616" y="464094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010753A5-64CD-F4A3-FED8-355AB197D5A7}"/>
                </a:ext>
              </a:extLst>
            </p:cNvPr>
            <p:cNvSpPr txBox="1"/>
            <p:nvPr/>
          </p:nvSpPr>
          <p:spPr>
            <a:xfrm>
              <a:off x="2815616" y="472760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8A810454-6061-6F9C-7BF2-7296E08CBAD2}"/>
                </a:ext>
              </a:extLst>
            </p:cNvPr>
            <p:cNvSpPr txBox="1"/>
            <p:nvPr/>
          </p:nvSpPr>
          <p:spPr>
            <a:xfrm>
              <a:off x="4027196" y="5052200"/>
              <a:ext cx="5405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UQCRC2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E78BFA55-2D5D-A41A-CA80-09F8BC444126}"/>
                </a:ext>
              </a:extLst>
            </p:cNvPr>
            <p:cNvSpPr txBox="1"/>
            <p:nvPr/>
          </p:nvSpPr>
          <p:spPr>
            <a:xfrm>
              <a:off x="4027196" y="5158275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DHB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4E7D9278-4B37-B9F3-031C-85DB13D86574}"/>
                </a:ext>
              </a:extLst>
            </p:cNvPr>
            <p:cNvSpPr txBox="1"/>
            <p:nvPr/>
          </p:nvSpPr>
          <p:spPr>
            <a:xfrm rot="19358159">
              <a:off x="4253865" y="4504555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</p:grp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F64CA886-2555-88F1-29B9-9683DF47736C}"/>
              </a:ext>
            </a:extLst>
          </p:cNvPr>
          <p:cNvGrpSpPr/>
          <p:nvPr/>
        </p:nvGrpSpPr>
        <p:grpSpPr>
          <a:xfrm>
            <a:off x="1656672" y="3256813"/>
            <a:ext cx="1853418" cy="1098550"/>
            <a:chOff x="2847899" y="3288052"/>
            <a:chExt cx="1853418" cy="1098550"/>
          </a:xfrm>
        </p:grpSpPr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4A101738-47DF-E417-6BC9-E0EFE02D0DA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205318" y="3288052"/>
              <a:ext cx="1473200" cy="1098550"/>
            </a:xfrm>
            <a:prstGeom prst="rect">
              <a:avLst/>
            </a:prstGeom>
          </p:spPr>
        </p:pic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9DE93C6F-9116-E52A-0E43-99548AD2A33A}"/>
                </a:ext>
              </a:extLst>
            </p:cNvPr>
            <p:cNvSpPr txBox="1"/>
            <p:nvPr/>
          </p:nvSpPr>
          <p:spPr>
            <a:xfrm>
              <a:off x="2847899" y="340588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35A7A25A-982A-1F90-74AC-DFDCBDA4FE13}"/>
                </a:ext>
              </a:extLst>
            </p:cNvPr>
            <p:cNvSpPr txBox="1"/>
            <p:nvPr/>
          </p:nvSpPr>
          <p:spPr>
            <a:xfrm>
              <a:off x="2847899" y="351360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FD9B7A8E-2CAA-19AB-3551-BEE7F4816755}"/>
                </a:ext>
              </a:extLst>
            </p:cNvPr>
            <p:cNvSpPr txBox="1"/>
            <p:nvPr/>
          </p:nvSpPr>
          <p:spPr>
            <a:xfrm>
              <a:off x="2847899" y="360026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975D4CA9-6242-4BB0-5511-FD88AFE09C0A}"/>
                </a:ext>
              </a:extLst>
            </p:cNvPr>
            <p:cNvSpPr/>
            <p:nvPr/>
          </p:nvSpPr>
          <p:spPr>
            <a:xfrm>
              <a:off x="4257675" y="3528883"/>
              <a:ext cx="209550" cy="112842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157176F4-676E-F966-581E-B6A547B53EA3}"/>
                </a:ext>
              </a:extLst>
            </p:cNvPr>
            <p:cNvSpPr txBox="1"/>
            <p:nvPr/>
          </p:nvSpPr>
          <p:spPr>
            <a:xfrm>
              <a:off x="4108794" y="394972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TP5A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77D614F1-B6EA-3F58-F2F9-9C38F749DBA3}"/>
                </a:ext>
              </a:extLst>
            </p:cNvPr>
            <p:cNvSpPr txBox="1"/>
            <p:nvPr/>
          </p:nvSpPr>
          <p:spPr>
            <a:xfrm rot="19358159">
              <a:off x="4160870" y="3305270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49C1EDC2-AB41-A317-D500-D62B85530C60}"/>
                </a:ext>
              </a:extLst>
            </p:cNvPr>
            <p:cNvSpPr txBox="1"/>
            <p:nvPr/>
          </p:nvSpPr>
          <p:spPr>
            <a:xfrm rot="19358159">
              <a:off x="4274597" y="3334634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</p:grpSp>
      <p:grpSp>
        <p:nvGrpSpPr>
          <p:cNvPr id="182" name="Group 181">
            <a:extLst>
              <a:ext uri="{FF2B5EF4-FFF2-40B4-BE49-F238E27FC236}">
                <a16:creationId xmlns:a16="http://schemas.microsoft.com/office/drawing/2014/main" id="{601CB6FC-6B4B-2958-8341-EDAA86F9CAE0}"/>
              </a:ext>
            </a:extLst>
          </p:cNvPr>
          <p:cNvGrpSpPr/>
          <p:nvPr/>
        </p:nvGrpSpPr>
        <p:grpSpPr>
          <a:xfrm>
            <a:off x="1626132" y="5602820"/>
            <a:ext cx="1890354" cy="1098550"/>
            <a:chOff x="2817359" y="5592784"/>
            <a:chExt cx="1890354" cy="1098550"/>
          </a:xfrm>
        </p:grpSpPr>
        <p:pic>
          <p:nvPicPr>
            <p:cNvPr id="183" name="Picture 182">
              <a:extLst>
                <a:ext uri="{FF2B5EF4-FFF2-40B4-BE49-F238E27FC236}">
                  <a16:creationId xmlns:a16="http://schemas.microsoft.com/office/drawing/2014/main" id="{FD3B0707-6FFC-569B-92F0-B6364E2055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187655" y="5592784"/>
              <a:ext cx="1473200" cy="1098550"/>
            </a:xfrm>
            <a:prstGeom prst="rect">
              <a:avLst/>
            </a:prstGeom>
          </p:spPr>
        </p:pic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7BE47837-016E-7B8D-E76B-4298B8E1FF11}"/>
                </a:ext>
              </a:extLst>
            </p:cNvPr>
            <p:cNvSpPr/>
            <p:nvPr/>
          </p:nvSpPr>
          <p:spPr>
            <a:xfrm>
              <a:off x="4264071" y="6003925"/>
              <a:ext cx="209550" cy="105590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08E8CA57-F2FB-D87E-B94F-7EB197A75691}"/>
                </a:ext>
              </a:extLst>
            </p:cNvPr>
            <p:cNvSpPr txBox="1"/>
            <p:nvPr/>
          </p:nvSpPr>
          <p:spPr>
            <a:xfrm rot="19358159">
              <a:off x="4167266" y="5771138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80099B8D-F8DC-DDA7-DD23-E51CAE8B2150}"/>
                </a:ext>
              </a:extLst>
            </p:cNvPr>
            <p:cNvSpPr txBox="1"/>
            <p:nvPr/>
          </p:nvSpPr>
          <p:spPr>
            <a:xfrm rot="19358159">
              <a:off x="4280993" y="5800502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A04E8F15-EE34-0FF3-0272-2D7A9F14BF54}"/>
                </a:ext>
              </a:extLst>
            </p:cNvPr>
            <p:cNvSpPr txBox="1"/>
            <p:nvPr/>
          </p:nvSpPr>
          <p:spPr>
            <a:xfrm>
              <a:off x="4276333" y="6156390"/>
              <a:ext cx="292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H3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4682C173-1A5D-4BFB-52D9-EA037FC6303F}"/>
                </a:ext>
              </a:extLst>
            </p:cNvPr>
            <p:cNvSpPr txBox="1"/>
            <p:nvPr/>
          </p:nvSpPr>
          <p:spPr>
            <a:xfrm>
              <a:off x="2817359" y="571799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9182831-B50A-5ACB-7486-594A13581A1D}"/>
                </a:ext>
              </a:extLst>
            </p:cNvPr>
            <p:cNvSpPr txBox="1"/>
            <p:nvPr/>
          </p:nvSpPr>
          <p:spPr>
            <a:xfrm>
              <a:off x="2817359" y="580349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0A94685F-8931-998B-8F8E-F741F7E80897}"/>
                </a:ext>
              </a:extLst>
            </p:cNvPr>
            <p:cNvSpPr txBox="1"/>
            <p:nvPr/>
          </p:nvSpPr>
          <p:spPr>
            <a:xfrm>
              <a:off x="2817359" y="594094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sp>
        <p:nvSpPr>
          <p:cNvPr id="191" name="TextBox 190">
            <a:extLst>
              <a:ext uri="{FF2B5EF4-FFF2-40B4-BE49-F238E27FC236}">
                <a16:creationId xmlns:a16="http://schemas.microsoft.com/office/drawing/2014/main" id="{E65F288A-5633-5B7B-E77D-336791269B1C}"/>
              </a:ext>
            </a:extLst>
          </p:cNvPr>
          <p:cNvSpPr txBox="1"/>
          <p:nvPr/>
        </p:nvSpPr>
        <p:spPr>
          <a:xfrm rot="19358159">
            <a:off x="2941749" y="4493967"/>
            <a:ext cx="4844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 Narrow" panose="020B0604020202020204" pitchFamily="34" charset="0"/>
                <a:cs typeface="Arial Narrow" panose="020B0604020202020204" pitchFamily="34" charset="0"/>
              </a:rPr>
              <a:t>scramble</a:t>
            </a:r>
          </a:p>
        </p:txBody>
      </p: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2258F197-9CE7-BB4E-FA22-0EDA93268274}"/>
              </a:ext>
            </a:extLst>
          </p:cNvPr>
          <p:cNvGrpSpPr/>
          <p:nvPr/>
        </p:nvGrpSpPr>
        <p:grpSpPr>
          <a:xfrm>
            <a:off x="3611658" y="3261477"/>
            <a:ext cx="1828801" cy="1098550"/>
            <a:chOff x="4802885" y="3251441"/>
            <a:chExt cx="1828801" cy="1098550"/>
          </a:xfrm>
        </p:grpSpPr>
        <p:pic>
          <p:nvPicPr>
            <p:cNvPr id="193" name="Picture 192">
              <a:extLst>
                <a:ext uri="{FF2B5EF4-FFF2-40B4-BE49-F238E27FC236}">
                  <a16:creationId xmlns:a16="http://schemas.microsoft.com/office/drawing/2014/main" id="{F9530B4A-F109-873B-6122-736C9FB666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158486" y="3251441"/>
              <a:ext cx="1473200" cy="1098550"/>
            </a:xfrm>
            <a:prstGeom prst="rect">
              <a:avLst/>
            </a:prstGeom>
          </p:spPr>
        </p:pic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7D80CCD3-2334-3BAF-B829-A27F413BC979}"/>
                </a:ext>
              </a:extLst>
            </p:cNvPr>
            <p:cNvSpPr/>
            <p:nvPr/>
          </p:nvSpPr>
          <p:spPr>
            <a:xfrm>
              <a:off x="6017873" y="3752898"/>
              <a:ext cx="178425" cy="129176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5E5F5472-5273-EB0D-985F-ADE19B5CA8EA}"/>
                </a:ext>
              </a:extLst>
            </p:cNvPr>
            <p:cNvSpPr txBox="1"/>
            <p:nvPr/>
          </p:nvSpPr>
          <p:spPr>
            <a:xfrm rot="19358159">
              <a:off x="5909316" y="3519754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5E1D627C-AD9E-7390-35D6-21D0C612C5D0}"/>
                </a:ext>
              </a:extLst>
            </p:cNvPr>
            <p:cNvSpPr txBox="1"/>
            <p:nvPr/>
          </p:nvSpPr>
          <p:spPr>
            <a:xfrm rot="19358159">
              <a:off x="6023043" y="3549118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A7575E78-AC31-A39B-D1B0-96D28C107C1A}"/>
                </a:ext>
              </a:extLst>
            </p:cNvPr>
            <p:cNvSpPr txBox="1"/>
            <p:nvPr/>
          </p:nvSpPr>
          <p:spPr>
            <a:xfrm>
              <a:off x="5999095" y="3962186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NDUFB8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DDF15279-AEA2-7B78-4C30-164CC892D20B}"/>
                </a:ext>
              </a:extLst>
            </p:cNvPr>
            <p:cNvSpPr txBox="1"/>
            <p:nvPr/>
          </p:nvSpPr>
          <p:spPr>
            <a:xfrm>
              <a:off x="4802885" y="369768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FE49ED54-94A6-A380-EF6B-D1317A4E2291}"/>
                </a:ext>
              </a:extLst>
            </p:cNvPr>
            <p:cNvSpPr txBox="1"/>
            <p:nvPr/>
          </p:nvSpPr>
          <p:spPr>
            <a:xfrm>
              <a:off x="4802885" y="346703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ED181068-2386-018E-8409-DC1EE052D475}"/>
                </a:ext>
              </a:extLst>
            </p:cNvPr>
            <p:cNvSpPr txBox="1"/>
            <p:nvPr/>
          </p:nvSpPr>
          <p:spPr>
            <a:xfrm>
              <a:off x="4802885" y="355369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201" name="Group 200">
            <a:extLst>
              <a:ext uri="{FF2B5EF4-FFF2-40B4-BE49-F238E27FC236}">
                <a16:creationId xmlns:a16="http://schemas.microsoft.com/office/drawing/2014/main" id="{88BC12E3-7E04-3218-D564-FB93A084BF4F}"/>
              </a:ext>
            </a:extLst>
          </p:cNvPr>
          <p:cNvGrpSpPr/>
          <p:nvPr/>
        </p:nvGrpSpPr>
        <p:grpSpPr>
          <a:xfrm>
            <a:off x="3611658" y="4439643"/>
            <a:ext cx="1828801" cy="1098550"/>
            <a:chOff x="4802885" y="4429607"/>
            <a:chExt cx="1828801" cy="1098550"/>
          </a:xfrm>
        </p:grpSpPr>
        <p:pic>
          <p:nvPicPr>
            <p:cNvPr id="202" name="Picture 201">
              <a:extLst>
                <a:ext uri="{FF2B5EF4-FFF2-40B4-BE49-F238E27FC236}">
                  <a16:creationId xmlns:a16="http://schemas.microsoft.com/office/drawing/2014/main" id="{30806DE5-071D-0B14-582D-D181A2B07F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158486" y="4429607"/>
              <a:ext cx="1473200" cy="1098550"/>
            </a:xfrm>
            <a:prstGeom prst="rect">
              <a:avLst/>
            </a:prstGeom>
          </p:spPr>
        </p:pic>
        <p:sp>
          <p:nvSpPr>
            <p:cNvPr id="203" name="Rectangle 202">
              <a:extLst>
                <a:ext uri="{FF2B5EF4-FFF2-40B4-BE49-F238E27FC236}">
                  <a16:creationId xmlns:a16="http://schemas.microsoft.com/office/drawing/2014/main" id="{FFF7419B-A99B-34D5-62D9-931BB48C2C37}"/>
                </a:ext>
              </a:extLst>
            </p:cNvPr>
            <p:cNvSpPr/>
            <p:nvPr/>
          </p:nvSpPr>
          <p:spPr>
            <a:xfrm>
              <a:off x="6071718" y="4827504"/>
              <a:ext cx="178425" cy="129176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FD26E1A3-41CF-53CB-80DE-02816DD721CB}"/>
                </a:ext>
              </a:extLst>
            </p:cNvPr>
            <p:cNvSpPr txBox="1"/>
            <p:nvPr/>
          </p:nvSpPr>
          <p:spPr>
            <a:xfrm rot="19358159">
              <a:off x="5968311" y="4592066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9CFFE82B-9535-DD1B-A746-23FC076D7884}"/>
                </a:ext>
              </a:extLst>
            </p:cNvPr>
            <p:cNvSpPr txBox="1"/>
            <p:nvPr/>
          </p:nvSpPr>
          <p:spPr>
            <a:xfrm rot="19358159">
              <a:off x="6082038" y="4621430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1277601C-D410-D29C-2C64-B81B62033537}"/>
                </a:ext>
              </a:extLst>
            </p:cNvPr>
            <p:cNvSpPr txBox="1"/>
            <p:nvPr/>
          </p:nvSpPr>
          <p:spPr>
            <a:xfrm>
              <a:off x="6239040" y="4988884"/>
              <a:ext cx="292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H3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AC9A6528-7BEE-00BF-E2A0-BA1CC81264A8}"/>
                </a:ext>
              </a:extLst>
            </p:cNvPr>
            <p:cNvSpPr txBox="1"/>
            <p:nvPr/>
          </p:nvSpPr>
          <p:spPr>
            <a:xfrm>
              <a:off x="4802885" y="477971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DA9A9622-606A-AA9E-6665-9820D92F3762}"/>
                </a:ext>
              </a:extLst>
            </p:cNvPr>
            <p:cNvSpPr txBox="1"/>
            <p:nvPr/>
          </p:nvSpPr>
          <p:spPr>
            <a:xfrm>
              <a:off x="4802885" y="454907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A2895CA3-C625-21BF-253C-B93259E69E0D}"/>
                </a:ext>
              </a:extLst>
            </p:cNvPr>
            <p:cNvSpPr txBox="1"/>
            <p:nvPr/>
          </p:nvSpPr>
          <p:spPr>
            <a:xfrm>
              <a:off x="4802885" y="463572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210" name="Group 209">
            <a:extLst>
              <a:ext uri="{FF2B5EF4-FFF2-40B4-BE49-F238E27FC236}">
                <a16:creationId xmlns:a16="http://schemas.microsoft.com/office/drawing/2014/main" id="{318D7601-D3D5-0FCE-19D6-040DC27415CF}"/>
              </a:ext>
            </a:extLst>
          </p:cNvPr>
          <p:cNvGrpSpPr/>
          <p:nvPr/>
        </p:nvGrpSpPr>
        <p:grpSpPr>
          <a:xfrm>
            <a:off x="3934620" y="5654705"/>
            <a:ext cx="1517580" cy="1098550"/>
            <a:chOff x="5125847" y="5644669"/>
            <a:chExt cx="1517580" cy="1098550"/>
          </a:xfrm>
        </p:grpSpPr>
        <p:pic>
          <p:nvPicPr>
            <p:cNvPr id="211" name="Picture 210">
              <a:extLst>
                <a:ext uri="{FF2B5EF4-FFF2-40B4-BE49-F238E27FC236}">
                  <a16:creationId xmlns:a16="http://schemas.microsoft.com/office/drawing/2014/main" id="{B789D19B-1338-A74D-8756-A75DC868871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158486" y="5644669"/>
              <a:ext cx="1473200" cy="1098550"/>
            </a:xfrm>
            <a:prstGeom prst="rect">
              <a:avLst/>
            </a:prstGeom>
          </p:spPr>
        </p:pic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14F24AFE-0302-5192-B8D7-DAB6DC48DBA2}"/>
                </a:ext>
              </a:extLst>
            </p:cNvPr>
            <p:cNvSpPr txBox="1"/>
            <p:nvPr/>
          </p:nvSpPr>
          <p:spPr>
            <a:xfrm>
              <a:off x="5125847" y="591466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DC94B2C2-B941-4BDA-25D0-330E0F36194D}"/>
                </a:ext>
              </a:extLst>
            </p:cNvPr>
            <p:cNvSpPr txBox="1"/>
            <p:nvPr/>
          </p:nvSpPr>
          <p:spPr>
            <a:xfrm>
              <a:off x="5125847" y="6005292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9B78B973-1515-DEB6-4F0E-5FBEF9774C29}"/>
                </a:ext>
              </a:extLst>
            </p:cNvPr>
            <p:cNvSpPr txBox="1"/>
            <p:nvPr/>
          </p:nvSpPr>
          <p:spPr>
            <a:xfrm>
              <a:off x="5125847" y="609194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AE408C5A-FD34-C229-3024-EF8524B188CB}"/>
                </a:ext>
              </a:extLst>
            </p:cNvPr>
            <p:cNvSpPr txBox="1"/>
            <p:nvPr/>
          </p:nvSpPr>
          <p:spPr>
            <a:xfrm>
              <a:off x="6136557" y="6352333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MT-CO1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A3B48765-0090-C791-3C7E-2EA24DA0EF5B}"/>
                </a:ext>
              </a:extLst>
            </p:cNvPr>
            <p:cNvSpPr txBox="1"/>
            <p:nvPr/>
          </p:nvSpPr>
          <p:spPr>
            <a:xfrm rot="19358159">
              <a:off x="5764437" y="5829450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A427B212-C16E-6B1C-1FC0-FBF835A4FA9F}"/>
                </a:ext>
              </a:extLst>
            </p:cNvPr>
            <p:cNvSpPr txBox="1"/>
            <p:nvPr/>
          </p:nvSpPr>
          <p:spPr>
            <a:xfrm rot="19358159">
              <a:off x="5878164" y="5858814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218" name="Rectangle 217">
              <a:extLst>
                <a:ext uri="{FF2B5EF4-FFF2-40B4-BE49-F238E27FC236}">
                  <a16:creationId xmlns:a16="http://schemas.microsoft.com/office/drawing/2014/main" id="{E36436A8-4B6C-F9A1-1ADD-D922FE8DFF84}"/>
                </a:ext>
              </a:extLst>
            </p:cNvPr>
            <p:cNvSpPr/>
            <p:nvPr/>
          </p:nvSpPr>
          <p:spPr>
            <a:xfrm>
              <a:off x="5879264" y="6065598"/>
              <a:ext cx="166801" cy="10222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19" name="Group 218">
            <a:extLst>
              <a:ext uri="{FF2B5EF4-FFF2-40B4-BE49-F238E27FC236}">
                <a16:creationId xmlns:a16="http://schemas.microsoft.com/office/drawing/2014/main" id="{46F68467-FBF2-2FBC-878E-A87DDE861162}"/>
              </a:ext>
            </a:extLst>
          </p:cNvPr>
          <p:cNvGrpSpPr/>
          <p:nvPr/>
        </p:nvGrpSpPr>
        <p:grpSpPr>
          <a:xfrm>
            <a:off x="3964082" y="6838200"/>
            <a:ext cx="1473200" cy="1098550"/>
            <a:chOff x="5155309" y="6828164"/>
            <a:chExt cx="1473200" cy="1098550"/>
          </a:xfrm>
        </p:grpSpPr>
        <p:pic>
          <p:nvPicPr>
            <p:cNvPr id="220" name="Picture 219">
              <a:extLst>
                <a:ext uri="{FF2B5EF4-FFF2-40B4-BE49-F238E27FC236}">
                  <a16:creationId xmlns:a16="http://schemas.microsoft.com/office/drawing/2014/main" id="{C212F2CC-0316-1716-A55A-2995017AC9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155309" y="6828164"/>
              <a:ext cx="1473200" cy="1098550"/>
            </a:xfrm>
            <a:prstGeom prst="rect">
              <a:avLst/>
            </a:prstGeom>
          </p:spPr>
        </p:pic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D33161FE-BA2C-4A37-60F9-74DDE87A95C1}"/>
                </a:ext>
              </a:extLst>
            </p:cNvPr>
            <p:cNvSpPr txBox="1"/>
            <p:nvPr/>
          </p:nvSpPr>
          <p:spPr>
            <a:xfrm>
              <a:off x="5155309" y="703636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7067091D-71D0-582D-6DFE-FE4EBBDBE7BB}"/>
                </a:ext>
              </a:extLst>
            </p:cNvPr>
            <p:cNvSpPr txBox="1"/>
            <p:nvPr/>
          </p:nvSpPr>
          <p:spPr>
            <a:xfrm>
              <a:off x="5155309" y="712699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D8821949-7663-7424-E4C8-DD1AB4B3F3A6}"/>
                </a:ext>
              </a:extLst>
            </p:cNvPr>
            <p:cNvSpPr txBox="1"/>
            <p:nvPr/>
          </p:nvSpPr>
          <p:spPr>
            <a:xfrm>
              <a:off x="5155309" y="7213649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DD44D77F-B37F-6FED-7EDF-065EC881A4F7}"/>
                </a:ext>
              </a:extLst>
            </p:cNvPr>
            <p:cNvSpPr txBox="1"/>
            <p:nvPr/>
          </p:nvSpPr>
          <p:spPr>
            <a:xfrm>
              <a:off x="6259743" y="7377439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A0D616EB-AA34-1897-F9D1-61FEDECE199B}"/>
                </a:ext>
              </a:extLst>
            </p:cNvPr>
            <p:cNvSpPr txBox="1"/>
            <p:nvPr/>
          </p:nvSpPr>
          <p:spPr>
            <a:xfrm rot="19358159">
              <a:off x="5801509" y="6925618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99E785F0-2182-77B5-EBB4-68D16EACB963}"/>
                </a:ext>
              </a:extLst>
            </p:cNvPr>
            <p:cNvSpPr txBox="1"/>
            <p:nvPr/>
          </p:nvSpPr>
          <p:spPr>
            <a:xfrm rot="19358159">
              <a:off x="5915236" y="6954982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227" name="Rectangle 226">
              <a:extLst>
                <a:ext uri="{FF2B5EF4-FFF2-40B4-BE49-F238E27FC236}">
                  <a16:creationId xmlns:a16="http://schemas.microsoft.com/office/drawing/2014/main" id="{60473C7B-9259-88CB-9894-2798163691EF}"/>
                </a:ext>
              </a:extLst>
            </p:cNvPr>
            <p:cNvSpPr/>
            <p:nvPr/>
          </p:nvSpPr>
          <p:spPr>
            <a:xfrm>
              <a:off x="5906169" y="7149580"/>
              <a:ext cx="166801" cy="10222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2561572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DD73037-2998-A442-9CCD-2686D458120F}"/>
              </a:ext>
            </a:extLst>
          </p:cNvPr>
          <p:cNvSpPr txBox="1"/>
          <p:nvPr/>
        </p:nvSpPr>
        <p:spPr>
          <a:xfrm>
            <a:off x="5452201" y="9595937"/>
            <a:ext cx="1388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Source data-WB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371870-8289-C25A-E5DA-F318C9BB1C22}"/>
              </a:ext>
            </a:extLst>
          </p:cNvPr>
          <p:cNvSpPr txBox="1"/>
          <p:nvPr/>
        </p:nvSpPr>
        <p:spPr>
          <a:xfrm>
            <a:off x="14198" y="149943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2F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C6E7CFD5-E5BC-E34B-5646-AB96B57B1203}"/>
              </a:ext>
            </a:extLst>
          </p:cNvPr>
          <p:cNvGrpSpPr/>
          <p:nvPr/>
        </p:nvGrpSpPr>
        <p:grpSpPr>
          <a:xfrm>
            <a:off x="60465" y="370771"/>
            <a:ext cx="1495247" cy="2399259"/>
            <a:chOff x="60465" y="370771"/>
            <a:chExt cx="1495247" cy="239925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5BF61955-87A9-93B3-14BD-16A018CDA6BA}"/>
                </a:ext>
              </a:extLst>
            </p:cNvPr>
            <p:cNvGrpSpPr/>
            <p:nvPr/>
          </p:nvGrpSpPr>
          <p:grpSpPr>
            <a:xfrm>
              <a:off x="60465" y="370771"/>
              <a:ext cx="1495247" cy="2384674"/>
              <a:chOff x="2656445" y="2054395"/>
              <a:chExt cx="1495247" cy="2384674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66F7DA32-6C3E-2E4D-0359-CB5624F79D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2728" t="44136" r="54502" b="37603"/>
              <a:stretch/>
            </p:blipFill>
            <p:spPr>
              <a:xfrm>
                <a:off x="3482116" y="2780509"/>
                <a:ext cx="451507" cy="48146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0C29C6A6-2DFA-AC9D-64BF-0F9FCD033C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2280" t="35840" r="44949" b="55370"/>
              <a:stretch/>
            </p:blipFill>
            <p:spPr>
              <a:xfrm>
                <a:off x="3482116" y="2318291"/>
                <a:ext cx="451508" cy="231735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97EF132F-7B2C-F66E-F498-3B28CB1CFD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2243" t="46544" r="43825" b="45503"/>
              <a:stretch/>
            </p:blipFill>
            <p:spPr>
              <a:xfrm>
                <a:off x="3482116" y="2569162"/>
                <a:ext cx="451507" cy="192211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A2A51E1-F97E-A605-2022-50CF0067F565}"/>
                  </a:ext>
                </a:extLst>
              </p:cNvPr>
              <p:cNvSpPr txBox="1"/>
              <p:nvPr/>
            </p:nvSpPr>
            <p:spPr>
              <a:xfrm>
                <a:off x="3238662" y="2326436"/>
                <a:ext cx="3161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IF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DE21602-7E94-D8BE-2BD2-135BDC02B14D}"/>
                  </a:ext>
                </a:extLst>
              </p:cNvPr>
              <p:cNvSpPr txBox="1"/>
              <p:nvPr/>
            </p:nvSpPr>
            <p:spPr>
              <a:xfrm>
                <a:off x="2833102" y="2890545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TCF4/TCF7L2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19823EB-B103-4DAB-5B1C-D0E25DC7623B}"/>
                  </a:ext>
                </a:extLst>
              </p:cNvPr>
              <p:cNvSpPr txBox="1"/>
              <p:nvPr/>
            </p:nvSpPr>
            <p:spPr>
              <a:xfrm>
                <a:off x="3192175" y="2545432"/>
                <a:ext cx="3625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ctin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C2134AD1-20C8-FFB5-7B78-997E22E5F332}"/>
                  </a:ext>
                </a:extLst>
              </p:cNvPr>
              <p:cNvSpPr txBox="1"/>
              <p:nvPr/>
            </p:nvSpPr>
            <p:spPr>
              <a:xfrm rot="19220584">
                <a:off x="3457076" y="2054395"/>
                <a:ext cx="5245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i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cramble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997455C-DA09-3999-D6D9-D9E75A389704}"/>
                  </a:ext>
                </a:extLst>
              </p:cNvPr>
              <p:cNvSpPr txBox="1"/>
              <p:nvPr/>
            </p:nvSpPr>
            <p:spPr>
              <a:xfrm rot="19220584">
                <a:off x="3689706" y="2075145"/>
                <a:ext cx="4619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i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iAifm1</a:t>
                </a:r>
              </a:p>
            </p:txBody>
          </p:sp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9C6614CE-3F86-E9E5-3CD5-588A70F4E4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5949" t="42015" r="50120" b="49239"/>
              <a:stretch/>
            </p:blipFill>
            <p:spPr>
              <a:xfrm>
                <a:off x="3482115" y="3281643"/>
                <a:ext cx="451507" cy="211382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703B331-40D6-DA46-3F59-882D972D4788}"/>
                  </a:ext>
                </a:extLst>
              </p:cNvPr>
              <p:cNvSpPr txBox="1"/>
              <p:nvPr/>
            </p:nvSpPr>
            <p:spPr>
              <a:xfrm>
                <a:off x="3192174" y="3254308"/>
                <a:ext cx="3626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ctin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8A51440-6222-CC11-F0E5-37EFA249F779}"/>
                  </a:ext>
                </a:extLst>
              </p:cNvPr>
              <p:cNvSpPr txBox="1"/>
              <p:nvPr/>
            </p:nvSpPr>
            <p:spPr>
              <a:xfrm>
                <a:off x="2656445" y="3453596"/>
                <a:ext cx="89832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non-phospho-(active)-</a:t>
                </a:r>
                <a:r>
                  <a:rPr lang="en-GB" sz="800" dirty="0">
                    <a:latin typeface="Symbol" pitchFamily="2" charset="2"/>
                    <a:cs typeface="Arial Narrow" panose="020B0604020202020204" pitchFamily="34" charset="0"/>
                  </a:rPr>
                  <a:t>b-</a:t>
                </a:r>
                <a:r>
                  <a:rPr lang="en-GB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catenin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E46853F-D9C0-2FDB-47D9-062FAAA4F5CB}"/>
                  </a:ext>
                </a:extLst>
              </p:cNvPr>
              <p:cNvSpPr txBox="1"/>
              <p:nvPr/>
            </p:nvSpPr>
            <p:spPr>
              <a:xfrm>
                <a:off x="3192174" y="3773199"/>
                <a:ext cx="3626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ctin</a:t>
                </a:r>
                <a:endParaRPr lang="en-US" sz="800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A021FC0-96AB-7A88-5631-8DABFC75D9F1}"/>
                  </a:ext>
                </a:extLst>
              </p:cNvPr>
              <p:cNvSpPr txBox="1"/>
              <p:nvPr/>
            </p:nvSpPr>
            <p:spPr>
              <a:xfrm>
                <a:off x="2986990" y="3987036"/>
                <a:ext cx="5677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00" dirty="0">
                    <a:latin typeface="Symbol" pitchFamily="2" charset="2"/>
                    <a:cs typeface="Arial Narrow" panose="020B0604020202020204" pitchFamily="34" charset="0"/>
                  </a:rPr>
                  <a:t>b-</a:t>
                </a:r>
                <a:r>
                  <a:rPr lang="en-GB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catenin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13834DCB-5522-F967-44E3-14D83D3C1A1D}"/>
                  </a:ext>
                </a:extLst>
              </p:cNvPr>
              <p:cNvSpPr txBox="1"/>
              <p:nvPr/>
            </p:nvSpPr>
            <p:spPr>
              <a:xfrm>
                <a:off x="3121642" y="4223625"/>
                <a:ext cx="4331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tubulin</a:t>
                </a:r>
              </a:p>
            </p:txBody>
          </p:sp>
        </p:grp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98D16FA-00EE-CF48-CDDA-F19C9D093D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6502" t="42677" r="50004" b="47485"/>
            <a:stretch/>
          </p:blipFill>
          <p:spPr>
            <a:xfrm>
              <a:off x="885868" y="1828010"/>
              <a:ext cx="451773" cy="24468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4CD7169-6F99-32F0-00E8-1BA57F9AE6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4087" t="51918" r="53049" b="40850"/>
            <a:stretch/>
          </p:blipFill>
          <p:spPr>
            <a:xfrm>
              <a:off x="887641" y="2083119"/>
              <a:ext cx="450000" cy="188625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189B701-D45E-6FD1-6E45-32C0F8A0EA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1450" t="48762" r="55719" b="42844"/>
            <a:stretch/>
          </p:blipFill>
          <p:spPr>
            <a:xfrm>
              <a:off x="890226" y="2550524"/>
              <a:ext cx="450000" cy="21950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452377E-5580-BE1B-5FD7-D9161DB62E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2870" t="37276" r="52804" b="52555"/>
            <a:stretch/>
          </p:blipFill>
          <p:spPr>
            <a:xfrm>
              <a:off x="888909" y="2287235"/>
              <a:ext cx="450000" cy="23818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B5CB5498-C51A-B9CB-096B-C99A3C59D095}"/>
              </a:ext>
            </a:extLst>
          </p:cNvPr>
          <p:cNvGrpSpPr/>
          <p:nvPr/>
        </p:nvGrpSpPr>
        <p:grpSpPr>
          <a:xfrm>
            <a:off x="1752073" y="1808371"/>
            <a:ext cx="1473200" cy="1098550"/>
            <a:chOff x="367602" y="1545730"/>
            <a:chExt cx="1473200" cy="1098550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6FCDE615-5E9D-5B79-DA2B-508F5BBF50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67602" y="1545730"/>
              <a:ext cx="1473200" cy="1098550"/>
            </a:xfrm>
            <a:prstGeom prst="rect">
              <a:avLst/>
            </a:prstGeom>
          </p:spPr>
        </p:pic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AF8B8D7-829C-12B9-0EF1-ED34AC390FE0}"/>
                </a:ext>
              </a:extLst>
            </p:cNvPr>
            <p:cNvSpPr/>
            <p:nvPr/>
          </p:nvSpPr>
          <p:spPr>
            <a:xfrm>
              <a:off x="993091" y="2050886"/>
              <a:ext cx="197093" cy="104358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3BA1A8C-D569-0607-E663-CF7133B140F8}"/>
                </a:ext>
              </a:extLst>
            </p:cNvPr>
            <p:cNvSpPr txBox="1"/>
            <p:nvPr/>
          </p:nvSpPr>
          <p:spPr>
            <a:xfrm rot="19358159">
              <a:off x="896286" y="1802799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7A638A5-2400-8357-190F-BE5959574508}"/>
                </a:ext>
              </a:extLst>
            </p:cNvPr>
            <p:cNvSpPr txBox="1"/>
            <p:nvPr/>
          </p:nvSpPr>
          <p:spPr>
            <a:xfrm rot="19358159">
              <a:off x="1010013" y="1832163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08F10EC-FA61-FE09-0EE8-121FD6286039}"/>
                </a:ext>
              </a:extLst>
            </p:cNvPr>
            <p:cNvSpPr txBox="1"/>
            <p:nvPr/>
          </p:nvSpPr>
          <p:spPr>
            <a:xfrm>
              <a:off x="591917" y="192480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721CCEB-7544-8653-3B72-52CF8E425D4C}"/>
                </a:ext>
              </a:extLst>
            </p:cNvPr>
            <p:cNvSpPr txBox="1"/>
            <p:nvPr/>
          </p:nvSpPr>
          <p:spPr>
            <a:xfrm>
              <a:off x="591917" y="209920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57C5FC5-B7FC-08B5-D4C6-9B76FCC9F2D2}"/>
                </a:ext>
              </a:extLst>
            </p:cNvPr>
            <p:cNvSpPr txBox="1"/>
            <p:nvPr/>
          </p:nvSpPr>
          <p:spPr>
            <a:xfrm>
              <a:off x="590763" y="182644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69AA8F7-F401-736E-D610-94BC80ABC6C9}"/>
                </a:ext>
              </a:extLst>
            </p:cNvPr>
            <p:cNvSpPr txBox="1"/>
            <p:nvPr/>
          </p:nvSpPr>
          <p:spPr>
            <a:xfrm>
              <a:off x="1085181" y="2242883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5345D642-76EE-1DC2-8082-F9EDFC5DA090}"/>
              </a:ext>
            </a:extLst>
          </p:cNvPr>
          <p:cNvGrpSpPr/>
          <p:nvPr/>
        </p:nvGrpSpPr>
        <p:grpSpPr>
          <a:xfrm>
            <a:off x="1771611" y="630205"/>
            <a:ext cx="1473200" cy="1098550"/>
            <a:chOff x="387140" y="367564"/>
            <a:chExt cx="1473200" cy="1098550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B729498A-6519-8F12-37A6-EF3FA8A898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87140" y="367564"/>
              <a:ext cx="1473200" cy="109855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57DF2D0-60AF-EB30-26DE-226DED653D04}"/>
                </a:ext>
              </a:extLst>
            </p:cNvPr>
            <p:cNvSpPr txBox="1"/>
            <p:nvPr/>
          </p:nvSpPr>
          <p:spPr>
            <a:xfrm rot="19358159">
              <a:off x="905812" y="512608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BEC59AC-BC1C-C9B0-CF17-D64E5993F141}"/>
                </a:ext>
              </a:extLst>
            </p:cNvPr>
            <p:cNvSpPr txBox="1"/>
            <p:nvPr/>
          </p:nvSpPr>
          <p:spPr>
            <a:xfrm rot="19358159">
              <a:off x="1019539" y="541972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D0C21E9A-EFC2-8FED-18D4-0AE45D13AAC7}"/>
                </a:ext>
              </a:extLst>
            </p:cNvPr>
            <p:cNvSpPr/>
            <p:nvPr/>
          </p:nvSpPr>
          <p:spPr>
            <a:xfrm>
              <a:off x="1003057" y="759699"/>
              <a:ext cx="197093" cy="104358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7B4560D-A9D6-3B05-72AD-62CB42506866}"/>
                </a:ext>
              </a:extLst>
            </p:cNvPr>
            <p:cNvSpPr txBox="1"/>
            <p:nvPr/>
          </p:nvSpPr>
          <p:spPr>
            <a:xfrm>
              <a:off x="593612" y="75300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DA3B4E39-70CB-C997-5224-D3E11C9C1B8E}"/>
                </a:ext>
              </a:extLst>
            </p:cNvPr>
            <p:cNvSpPr txBox="1"/>
            <p:nvPr/>
          </p:nvSpPr>
          <p:spPr>
            <a:xfrm>
              <a:off x="593612" y="92739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633EFC5-E16D-0F83-36CA-C2FED477492A}"/>
                </a:ext>
              </a:extLst>
            </p:cNvPr>
            <p:cNvSpPr txBox="1"/>
            <p:nvPr/>
          </p:nvSpPr>
          <p:spPr>
            <a:xfrm>
              <a:off x="592458" y="654634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4DA65EC-ECAB-FCAF-006B-AE7BFCF6541F}"/>
                </a:ext>
              </a:extLst>
            </p:cNvPr>
            <p:cNvSpPr txBox="1"/>
            <p:nvPr/>
          </p:nvSpPr>
          <p:spPr>
            <a:xfrm>
              <a:off x="1113998" y="1072802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IF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A967B1D2-699C-0A59-746A-289B4F6B375F}"/>
              </a:ext>
            </a:extLst>
          </p:cNvPr>
          <p:cNvGrpSpPr/>
          <p:nvPr/>
        </p:nvGrpSpPr>
        <p:grpSpPr>
          <a:xfrm>
            <a:off x="3389118" y="634085"/>
            <a:ext cx="1473200" cy="1098550"/>
            <a:chOff x="2004647" y="371444"/>
            <a:chExt cx="1473200" cy="1098550"/>
          </a:xfrm>
        </p:grpSpPr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5B59F783-789B-48EC-BD0D-4D958E2BE74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004647" y="371444"/>
              <a:ext cx="1473200" cy="1098550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2E75657-A918-D41C-B9F1-2BE4CEBFC5A4}"/>
                </a:ext>
              </a:extLst>
            </p:cNvPr>
            <p:cNvSpPr txBox="1"/>
            <p:nvPr/>
          </p:nvSpPr>
          <p:spPr>
            <a:xfrm>
              <a:off x="2066143" y="908522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F9B92478-DBC8-406B-71FD-D3083493E806}"/>
                </a:ext>
              </a:extLst>
            </p:cNvPr>
            <p:cNvSpPr txBox="1"/>
            <p:nvPr/>
          </p:nvSpPr>
          <p:spPr>
            <a:xfrm>
              <a:off x="2066143" y="1051169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B46BEEE2-F46B-B4C9-1C61-43B7B7269DF8}"/>
                </a:ext>
              </a:extLst>
            </p:cNvPr>
            <p:cNvSpPr txBox="1"/>
            <p:nvPr/>
          </p:nvSpPr>
          <p:spPr>
            <a:xfrm>
              <a:off x="2064989" y="81015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62CA707-2D9A-41DB-44D2-4F303993BAD0}"/>
                </a:ext>
              </a:extLst>
            </p:cNvPr>
            <p:cNvSpPr txBox="1"/>
            <p:nvPr/>
          </p:nvSpPr>
          <p:spPr>
            <a:xfrm rot="19358159">
              <a:off x="2384951" y="633408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F10F6E00-46A9-ACF4-9ED5-0A4E42038146}"/>
                </a:ext>
              </a:extLst>
            </p:cNvPr>
            <p:cNvSpPr txBox="1"/>
            <p:nvPr/>
          </p:nvSpPr>
          <p:spPr>
            <a:xfrm rot="19358159">
              <a:off x="2498678" y="662772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6E62EA4-8FB4-E18C-05FF-4A134080F83B}"/>
                </a:ext>
              </a:extLst>
            </p:cNvPr>
            <p:cNvSpPr txBox="1"/>
            <p:nvPr/>
          </p:nvSpPr>
          <p:spPr>
            <a:xfrm>
              <a:off x="2481755" y="1159293"/>
              <a:ext cx="4780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TCF4/ TCF7L2</a:t>
              </a: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42D8353C-5164-F1AA-67CC-FECCB0F92A27}"/>
                </a:ext>
              </a:extLst>
            </p:cNvPr>
            <p:cNvSpPr/>
            <p:nvPr/>
          </p:nvSpPr>
          <p:spPr>
            <a:xfrm>
              <a:off x="2481755" y="873431"/>
              <a:ext cx="196525" cy="194625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912AFE52-2AA8-B197-316D-012A5C15BB51}"/>
              </a:ext>
            </a:extLst>
          </p:cNvPr>
          <p:cNvGrpSpPr/>
          <p:nvPr/>
        </p:nvGrpSpPr>
        <p:grpSpPr>
          <a:xfrm>
            <a:off x="3389118" y="1808371"/>
            <a:ext cx="1473200" cy="1098550"/>
            <a:chOff x="2004647" y="1545730"/>
            <a:chExt cx="1473200" cy="1098550"/>
          </a:xfrm>
        </p:grpSpPr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509D42EF-4D15-DA3F-85AF-685964F815A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004647" y="1545730"/>
              <a:ext cx="1473200" cy="1098550"/>
            </a:xfrm>
            <a:prstGeom prst="rect">
              <a:avLst/>
            </a:prstGeom>
          </p:spPr>
        </p:pic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4F24EF0C-C3DF-4A9B-A705-E00C6C87ECD8}"/>
                </a:ext>
              </a:extLst>
            </p:cNvPr>
            <p:cNvSpPr txBox="1"/>
            <p:nvPr/>
          </p:nvSpPr>
          <p:spPr>
            <a:xfrm>
              <a:off x="2130807" y="188474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F071DD14-E688-1E2E-EE6D-B77F94856F4A}"/>
                </a:ext>
              </a:extLst>
            </p:cNvPr>
            <p:cNvSpPr txBox="1"/>
            <p:nvPr/>
          </p:nvSpPr>
          <p:spPr>
            <a:xfrm>
              <a:off x="2130807" y="202739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31B4696-9519-7C9A-2E1F-7563ED8A7B3E}"/>
                </a:ext>
              </a:extLst>
            </p:cNvPr>
            <p:cNvSpPr txBox="1"/>
            <p:nvPr/>
          </p:nvSpPr>
          <p:spPr>
            <a:xfrm>
              <a:off x="2129653" y="178638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0D84007F-6884-96B7-89A9-89AEEE8621BD}"/>
                </a:ext>
              </a:extLst>
            </p:cNvPr>
            <p:cNvSpPr txBox="1"/>
            <p:nvPr/>
          </p:nvSpPr>
          <p:spPr>
            <a:xfrm rot="19358159">
              <a:off x="2436066" y="1759997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8E38254-0EDC-B6D6-ADB9-66FD7925B15C}"/>
                </a:ext>
              </a:extLst>
            </p:cNvPr>
            <p:cNvSpPr txBox="1"/>
            <p:nvPr/>
          </p:nvSpPr>
          <p:spPr>
            <a:xfrm rot="19358159">
              <a:off x="2549793" y="1789361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4A0144AE-8E36-915D-4205-9F75B7C2BD9E}"/>
                </a:ext>
              </a:extLst>
            </p:cNvPr>
            <p:cNvSpPr txBox="1"/>
            <p:nvPr/>
          </p:nvSpPr>
          <p:spPr>
            <a:xfrm>
              <a:off x="2616934" y="2216166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81DB72E5-9E70-D469-0B4F-A936440692AD}"/>
                </a:ext>
              </a:extLst>
            </p:cNvPr>
            <p:cNvSpPr/>
            <p:nvPr/>
          </p:nvSpPr>
          <p:spPr>
            <a:xfrm>
              <a:off x="2532870" y="1990213"/>
              <a:ext cx="196525" cy="13554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361A41DA-0AF1-D94A-5DD9-A48EA456551D}"/>
              </a:ext>
            </a:extLst>
          </p:cNvPr>
          <p:cNvGrpSpPr/>
          <p:nvPr/>
        </p:nvGrpSpPr>
        <p:grpSpPr>
          <a:xfrm>
            <a:off x="1752073" y="2953796"/>
            <a:ext cx="1524483" cy="2281903"/>
            <a:chOff x="4993790" y="630205"/>
            <a:chExt cx="1524483" cy="2281903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C46197C1-0A07-CD6E-DBE6-632CE457B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996636" y="630205"/>
              <a:ext cx="1473200" cy="1098550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250A252B-2620-3E5F-6EE1-536923ADC3A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993790" y="1813558"/>
              <a:ext cx="1473200" cy="1098550"/>
            </a:xfrm>
            <a:prstGeom prst="rect">
              <a:avLst/>
            </a:prstGeom>
          </p:spPr>
        </p:pic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38FC93A5-8973-5046-2E9D-6E400646EF8D}"/>
                </a:ext>
              </a:extLst>
            </p:cNvPr>
            <p:cNvSpPr txBox="1"/>
            <p:nvPr/>
          </p:nvSpPr>
          <p:spPr>
            <a:xfrm>
              <a:off x="5134143" y="120009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2953D025-8A89-D906-1280-B32B9526FE8A}"/>
                </a:ext>
              </a:extLst>
            </p:cNvPr>
            <p:cNvSpPr txBox="1"/>
            <p:nvPr/>
          </p:nvSpPr>
          <p:spPr>
            <a:xfrm>
              <a:off x="5134143" y="135544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2D544F0-0A95-51C9-3D48-290F9E2232BC}"/>
                </a:ext>
              </a:extLst>
            </p:cNvPr>
            <p:cNvSpPr txBox="1"/>
            <p:nvPr/>
          </p:nvSpPr>
          <p:spPr>
            <a:xfrm>
              <a:off x="5132989" y="1101729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01DD51E-52BC-A6E3-ED54-38B7656F990A}"/>
                </a:ext>
              </a:extLst>
            </p:cNvPr>
            <p:cNvSpPr txBox="1"/>
            <p:nvPr/>
          </p:nvSpPr>
          <p:spPr>
            <a:xfrm>
              <a:off x="5076374" y="226024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77ADE41-C8C7-C4DC-6486-671EA22BA007}"/>
                </a:ext>
              </a:extLst>
            </p:cNvPr>
            <p:cNvSpPr txBox="1"/>
            <p:nvPr/>
          </p:nvSpPr>
          <p:spPr>
            <a:xfrm>
              <a:off x="5076374" y="242511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EA39B497-B159-B502-3910-D094300AD404}"/>
                </a:ext>
              </a:extLst>
            </p:cNvPr>
            <p:cNvSpPr txBox="1"/>
            <p:nvPr/>
          </p:nvSpPr>
          <p:spPr>
            <a:xfrm>
              <a:off x="5075220" y="2161879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2B611663-0003-8778-99C6-BCA74F1B5983}"/>
                </a:ext>
              </a:extLst>
            </p:cNvPr>
            <p:cNvSpPr txBox="1"/>
            <p:nvPr/>
          </p:nvSpPr>
          <p:spPr>
            <a:xfrm rot="19358159">
              <a:off x="5450215" y="873326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454D8A24-A52C-F5CA-3847-DB46473305A0}"/>
                </a:ext>
              </a:extLst>
            </p:cNvPr>
            <p:cNvSpPr txBox="1"/>
            <p:nvPr/>
          </p:nvSpPr>
          <p:spPr>
            <a:xfrm rot="19358159">
              <a:off x="5563942" y="902690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CE142DA9-E3F5-4DA2-67B5-BE3AC1EE5EF5}"/>
                </a:ext>
              </a:extLst>
            </p:cNvPr>
            <p:cNvSpPr txBox="1"/>
            <p:nvPr/>
          </p:nvSpPr>
          <p:spPr>
            <a:xfrm rot="19358159">
              <a:off x="5396356" y="2151120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01C5F7DF-8121-880C-0DC3-471EF3A0C337}"/>
                </a:ext>
              </a:extLst>
            </p:cNvPr>
            <p:cNvSpPr txBox="1"/>
            <p:nvPr/>
          </p:nvSpPr>
          <p:spPr>
            <a:xfrm rot="19358159">
              <a:off x="5510083" y="2180484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E3876CD4-1BC8-4F8A-7321-BF000909A470}"/>
                </a:ext>
              </a:extLst>
            </p:cNvPr>
            <p:cNvSpPr/>
            <p:nvPr/>
          </p:nvSpPr>
          <p:spPr>
            <a:xfrm>
              <a:off x="5540215" y="1096914"/>
              <a:ext cx="196525" cy="11478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212BF62B-F84B-FF62-2610-CAB4A10141CA}"/>
                </a:ext>
              </a:extLst>
            </p:cNvPr>
            <p:cNvSpPr/>
            <p:nvPr/>
          </p:nvSpPr>
          <p:spPr>
            <a:xfrm>
              <a:off x="5493655" y="2384914"/>
              <a:ext cx="196525" cy="114789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654E900A-57EA-7566-6687-74EEC2311C16}"/>
                </a:ext>
              </a:extLst>
            </p:cNvPr>
            <p:cNvSpPr txBox="1"/>
            <p:nvPr/>
          </p:nvSpPr>
          <p:spPr>
            <a:xfrm>
              <a:off x="5888823" y="1063971"/>
              <a:ext cx="62945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non-phospho-</a:t>
              </a:r>
              <a:r>
                <a:rPr lang="en-GB" sz="700" dirty="0">
                  <a:solidFill>
                    <a:schemeClr val="bg1"/>
                  </a:solidFill>
                  <a:latin typeface="Symbol" pitchFamily="2" charset="2"/>
                  <a:cs typeface="Arial Narrow" panose="020B0604020202020204" pitchFamily="34" charset="0"/>
                </a:rPr>
                <a:t>b</a:t>
              </a:r>
            </a:p>
            <a:p>
              <a:r>
                <a:rPr lang="en-GB" sz="7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-catenin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8972C36-3CC0-C7B0-0D06-5B6B9F54B282}"/>
                </a:ext>
              </a:extLst>
            </p:cNvPr>
            <p:cNvSpPr txBox="1"/>
            <p:nvPr/>
          </p:nvSpPr>
          <p:spPr>
            <a:xfrm>
              <a:off x="5608395" y="2494782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</p:grpSp>
      <p:grpSp>
        <p:nvGrpSpPr>
          <p:cNvPr id="238" name="Group 237">
            <a:extLst>
              <a:ext uri="{FF2B5EF4-FFF2-40B4-BE49-F238E27FC236}">
                <a16:creationId xmlns:a16="http://schemas.microsoft.com/office/drawing/2014/main" id="{69334E56-F2F4-EBE3-366E-1A62F72B2317}"/>
              </a:ext>
            </a:extLst>
          </p:cNvPr>
          <p:cNvGrpSpPr/>
          <p:nvPr/>
        </p:nvGrpSpPr>
        <p:grpSpPr>
          <a:xfrm>
            <a:off x="3350866" y="2952399"/>
            <a:ext cx="1474236" cy="2298645"/>
            <a:chOff x="6592583" y="628808"/>
            <a:chExt cx="1474236" cy="2298645"/>
          </a:xfrm>
        </p:grpSpPr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931F2D68-4A45-90B0-0F59-15680450F891}"/>
                </a:ext>
              </a:extLst>
            </p:cNvPr>
            <p:cNvGrpSpPr/>
            <p:nvPr/>
          </p:nvGrpSpPr>
          <p:grpSpPr>
            <a:xfrm>
              <a:off x="6592583" y="628808"/>
              <a:ext cx="1473200" cy="1098550"/>
              <a:chOff x="5354924" y="464765"/>
              <a:chExt cx="1473200" cy="1098550"/>
            </a:xfrm>
          </p:grpSpPr>
          <p:pic>
            <p:nvPicPr>
              <p:cNvPr id="137" name="Picture 136">
                <a:extLst>
                  <a:ext uri="{FF2B5EF4-FFF2-40B4-BE49-F238E27FC236}">
                    <a16:creationId xmlns:a16="http://schemas.microsoft.com/office/drawing/2014/main" id="{442EADB9-5780-35D0-2174-24BB483F4E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5354924" y="464765"/>
                <a:ext cx="1473200" cy="1098550"/>
              </a:xfrm>
              <a:prstGeom prst="rect">
                <a:avLst/>
              </a:prstGeom>
            </p:spPr>
          </p:pic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61B11166-3400-34E0-1BA4-57FF81EFD15D}"/>
                  </a:ext>
                </a:extLst>
              </p:cNvPr>
              <p:cNvSpPr txBox="1"/>
              <p:nvPr/>
            </p:nvSpPr>
            <p:spPr>
              <a:xfrm>
                <a:off x="5443909" y="974882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55 </a:t>
                </a:r>
                <a:r>
                  <a:rPr lang="en-GB" sz="800" dirty="0" err="1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kDa</a:t>
                </a:r>
                <a:endPara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159846AD-027B-D112-1A80-7B5DE52AE17D}"/>
                  </a:ext>
                </a:extLst>
              </p:cNvPr>
              <p:cNvSpPr txBox="1"/>
              <p:nvPr/>
            </p:nvSpPr>
            <p:spPr>
              <a:xfrm>
                <a:off x="5443909" y="1139754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38 </a:t>
                </a:r>
                <a:r>
                  <a:rPr lang="en-GB" sz="800" dirty="0" err="1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kDa</a:t>
                </a:r>
                <a:endPara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EF5C8920-28C1-FE76-A322-E37DC2F6C3FA}"/>
                  </a:ext>
                </a:extLst>
              </p:cNvPr>
              <p:cNvSpPr txBox="1"/>
              <p:nvPr/>
            </p:nvSpPr>
            <p:spPr>
              <a:xfrm>
                <a:off x="5442755" y="876515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75 </a:t>
                </a:r>
                <a:r>
                  <a:rPr lang="en-GB" sz="800" dirty="0" err="1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kDa</a:t>
                </a:r>
                <a:endPara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7E83AB25-2B27-45F5-135F-98F7095EC8EB}"/>
                  </a:ext>
                </a:extLst>
              </p:cNvPr>
              <p:cNvSpPr txBox="1"/>
              <p:nvPr/>
            </p:nvSpPr>
            <p:spPr>
              <a:xfrm rot="19358159">
                <a:off x="5764438" y="641824"/>
                <a:ext cx="4844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cramble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559F3836-C1C2-7835-52BA-E10D2137D298}"/>
                  </a:ext>
                </a:extLst>
              </p:cNvPr>
              <p:cNvSpPr txBox="1"/>
              <p:nvPr/>
            </p:nvSpPr>
            <p:spPr>
              <a:xfrm rot="19358159">
                <a:off x="5878165" y="671188"/>
                <a:ext cx="4267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i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iAifm1</a:t>
                </a:r>
              </a:p>
            </p:txBody>
          </p:sp>
          <p:sp>
            <p:nvSpPr>
              <p:cNvPr id="143" name="Rectangle 142">
                <a:extLst>
                  <a:ext uri="{FF2B5EF4-FFF2-40B4-BE49-F238E27FC236}">
                    <a16:creationId xmlns:a16="http://schemas.microsoft.com/office/drawing/2014/main" id="{5DDBBB9A-01DB-731A-F170-A7CDCE212160}"/>
                  </a:ext>
                </a:extLst>
              </p:cNvPr>
              <p:cNvSpPr/>
              <p:nvPr/>
            </p:nvSpPr>
            <p:spPr>
              <a:xfrm>
                <a:off x="5865012" y="872254"/>
                <a:ext cx="182048" cy="117813"/>
              </a:xfrm>
              <a:prstGeom prst="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0A53643A-6BBD-5146-2AF8-713ED7CCB5CB}"/>
                  </a:ext>
                </a:extLst>
              </p:cNvPr>
              <p:cNvSpPr txBox="1"/>
              <p:nvPr/>
            </p:nvSpPr>
            <p:spPr>
              <a:xfrm>
                <a:off x="5783307" y="1152097"/>
                <a:ext cx="5809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Symbol" pitchFamily="2" charset="2"/>
                    <a:cs typeface="Arial Narrow" panose="020B0604020202020204" pitchFamily="34" charset="0"/>
                  </a:rPr>
                  <a:t>b</a:t>
                </a:r>
                <a:r>
                  <a:rPr lang="en-GB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-catenin</a:t>
                </a:r>
              </a:p>
            </p:txBody>
          </p:sp>
        </p:grpSp>
        <p:grpSp>
          <p:nvGrpSpPr>
            <p:cNvPr id="228" name="Group 227">
              <a:extLst>
                <a:ext uri="{FF2B5EF4-FFF2-40B4-BE49-F238E27FC236}">
                  <a16:creationId xmlns:a16="http://schemas.microsoft.com/office/drawing/2014/main" id="{6187F104-D51D-3F6D-8CEE-7CEA6E5B2CAC}"/>
                </a:ext>
              </a:extLst>
            </p:cNvPr>
            <p:cNvGrpSpPr/>
            <p:nvPr/>
          </p:nvGrpSpPr>
          <p:grpSpPr>
            <a:xfrm>
              <a:off x="6593619" y="1828903"/>
              <a:ext cx="1473200" cy="1098550"/>
              <a:chOff x="5328948" y="1580900"/>
              <a:chExt cx="1473200" cy="1098550"/>
            </a:xfrm>
          </p:grpSpPr>
          <p:pic>
            <p:nvPicPr>
              <p:cNvPr id="229" name="Picture 228">
                <a:extLst>
                  <a:ext uri="{FF2B5EF4-FFF2-40B4-BE49-F238E27FC236}">
                    <a16:creationId xmlns:a16="http://schemas.microsoft.com/office/drawing/2014/main" id="{C23CAE9D-E9DC-9162-6C5B-65D9409C7E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5328948" y="1580900"/>
                <a:ext cx="1473200" cy="1098550"/>
              </a:xfrm>
              <a:prstGeom prst="rect">
                <a:avLst/>
              </a:prstGeom>
            </p:spPr>
          </p:pic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43E230E5-0AAE-C011-F9D8-089096B30FC4}"/>
                  </a:ext>
                </a:extLst>
              </p:cNvPr>
              <p:cNvSpPr txBox="1"/>
              <p:nvPr/>
            </p:nvSpPr>
            <p:spPr>
              <a:xfrm>
                <a:off x="5391018" y="2051294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55 </a:t>
                </a:r>
                <a:r>
                  <a:rPr lang="en-GB" sz="800" dirty="0" err="1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kDa</a:t>
                </a:r>
                <a:endPara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C27CD9C8-614E-7441-650C-8CCA9BB44FCC}"/>
                  </a:ext>
                </a:extLst>
              </p:cNvPr>
              <p:cNvSpPr txBox="1"/>
              <p:nvPr/>
            </p:nvSpPr>
            <p:spPr>
              <a:xfrm>
                <a:off x="5391018" y="2216166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38 </a:t>
                </a:r>
                <a:r>
                  <a:rPr lang="en-GB" sz="800" dirty="0" err="1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kDa</a:t>
                </a:r>
                <a:endPara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03C5C028-AD7D-CFD6-E61B-D5EC94BD6FCF}"/>
                  </a:ext>
                </a:extLst>
              </p:cNvPr>
              <p:cNvSpPr txBox="1"/>
              <p:nvPr/>
            </p:nvSpPr>
            <p:spPr>
              <a:xfrm>
                <a:off x="5389864" y="1952927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75 </a:t>
                </a:r>
                <a:r>
                  <a:rPr lang="en-GB" sz="800" dirty="0" err="1">
                    <a:solidFill>
                      <a:schemeClr val="bg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rPr>
                  <a:t>kDa</a:t>
                </a:r>
                <a:endPara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EA276609-9DCF-AC90-6CDB-2AA10690C3AF}"/>
                  </a:ext>
                </a:extLst>
              </p:cNvPr>
              <p:cNvSpPr txBox="1"/>
              <p:nvPr/>
            </p:nvSpPr>
            <p:spPr>
              <a:xfrm rot="19358159">
                <a:off x="5702498" y="1889673"/>
                <a:ext cx="4844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cramble</a:t>
                </a: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AE671678-4E37-8904-1F61-B1CFB2DC5708}"/>
                  </a:ext>
                </a:extLst>
              </p:cNvPr>
              <p:cNvSpPr txBox="1"/>
              <p:nvPr/>
            </p:nvSpPr>
            <p:spPr>
              <a:xfrm rot="19358159">
                <a:off x="5816225" y="1919037"/>
                <a:ext cx="4267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i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siAifm1</a:t>
                </a:r>
              </a:p>
            </p:txBody>
          </p:sp>
          <p:sp>
            <p:nvSpPr>
              <p:cNvPr id="235" name="Rectangle 234">
                <a:extLst>
                  <a:ext uri="{FF2B5EF4-FFF2-40B4-BE49-F238E27FC236}">
                    <a16:creationId xmlns:a16="http://schemas.microsoft.com/office/drawing/2014/main" id="{399728EE-17A7-42EA-F9E7-DF65938862E6}"/>
                  </a:ext>
                </a:extLst>
              </p:cNvPr>
              <p:cNvSpPr/>
              <p:nvPr/>
            </p:nvSpPr>
            <p:spPr>
              <a:xfrm>
                <a:off x="5799302" y="2122273"/>
                <a:ext cx="182048" cy="117813"/>
              </a:xfrm>
              <a:prstGeom prst="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C02F4A2C-B0B9-793D-8EFB-7A9062B94B68}"/>
                  </a:ext>
                </a:extLst>
              </p:cNvPr>
              <p:cNvSpPr txBox="1"/>
              <p:nvPr/>
            </p:nvSpPr>
            <p:spPr>
              <a:xfrm>
                <a:off x="5827441" y="2289994"/>
                <a:ext cx="4331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tubulin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575388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DD73037-2998-A442-9CCD-2686D458120F}"/>
              </a:ext>
            </a:extLst>
          </p:cNvPr>
          <p:cNvSpPr txBox="1"/>
          <p:nvPr/>
        </p:nvSpPr>
        <p:spPr>
          <a:xfrm>
            <a:off x="5452201" y="9595937"/>
            <a:ext cx="1388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Source data-WB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371870-8289-C25A-E5DA-F318C9BB1C22}"/>
              </a:ext>
            </a:extLst>
          </p:cNvPr>
          <p:cNvSpPr txBox="1"/>
          <p:nvPr/>
        </p:nvSpPr>
        <p:spPr>
          <a:xfrm>
            <a:off x="1374" y="149943"/>
            <a:ext cx="3898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2G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E9F6639-606A-A391-A982-6A8B1B79315A}"/>
              </a:ext>
            </a:extLst>
          </p:cNvPr>
          <p:cNvGrpSpPr/>
          <p:nvPr/>
        </p:nvGrpSpPr>
        <p:grpSpPr>
          <a:xfrm>
            <a:off x="99649" y="365898"/>
            <a:ext cx="1061406" cy="2655198"/>
            <a:chOff x="368481" y="3338127"/>
            <a:chExt cx="1061406" cy="2655198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44C91ADD-01BB-5C10-3067-1D6E51C7C05F}"/>
                </a:ext>
              </a:extLst>
            </p:cNvPr>
            <p:cNvGrpSpPr/>
            <p:nvPr/>
          </p:nvGrpSpPr>
          <p:grpSpPr>
            <a:xfrm>
              <a:off x="368481" y="3338127"/>
              <a:ext cx="1061406" cy="2655198"/>
              <a:chOff x="254216" y="4448505"/>
              <a:chExt cx="1061406" cy="2655198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D631D1A9-FC5A-0037-5632-BBFABF5519D7}"/>
                  </a:ext>
                </a:extLst>
              </p:cNvPr>
              <p:cNvGrpSpPr/>
              <p:nvPr/>
            </p:nvGrpSpPr>
            <p:grpSpPr>
              <a:xfrm>
                <a:off x="254216" y="4448505"/>
                <a:ext cx="1061406" cy="2655198"/>
                <a:chOff x="579735" y="4229441"/>
                <a:chExt cx="1061406" cy="2655198"/>
              </a:xfrm>
            </p:grpSpPr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20D6449F-3E1B-9AA4-7248-FF360D5B1D43}"/>
                    </a:ext>
                  </a:extLst>
                </p:cNvPr>
                <p:cNvSpPr txBox="1"/>
                <p:nvPr/>
              </p:nvSpPr>
              <p:spPr>
                <a:xfrm>
                  <a:off x="603781" y="5359604"/>
                  <a:ext cx="48763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BAF170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EBEFA05E-7972-1A4E-4521-8C9AF5F243B8}"/>
                    </a:ext>
                  </a:extLst>
                </p:cNvPr>
                <p:cNvSpPr txBox="1"/>
                <p:nvPr/>
              </p:nvSpPr>
              <p:spPr>
                <a:xfrm>
                  <a:off x="672710" y="5604834"/>
                  <a:ext cx="4187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DHA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4BE9FF63-FA32-6811-AC26-C1DCF58C4CB8}"/>
                    </a:ext>
                  </a:extLst>
                </p:cNvPr>
                <p:cNvSpPr txBox="1"/>
                <p:nvPr/>
              </p:nvSpPr>
              <p:spPr>
                <a:xfrm>
                  <a:off x="719197" y="5829937"/>
                  <a:ext cx="3722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BRM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87C708E2-91A1-A300-8426-7B384031FFD2}"/>
                    </a:ext>
                  </a:extLst>
                </p:cNvPr>
                <p:cNvSpPr txBox="1"/>
                <p:nvPr/>
              </p:nvSpPr>
              <p:spPr>
                <a:xfrm>
                  <a:off x="728815" y="6105584"/>
                  <a:ext cx="3626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ctin</a:t>
                  </a:r>
                </a:p>
              </p:txBody>
            </p:sp>
            <p:pic>
              <p:nvPicPr>
                <p:cNvPr id="54" name="Picture 53">
                  <a:extLst>
                    <a:ext uri="{FF2B5EF4-FFF2-40B4-BE49-F238E27FC236}">
                      <a16:creationId xmlns:a16="http://schemas.microsoft.com/office/drawing/2014/main" id="{57A49C76-8407-C2A5-0344-9294727521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6855" t="35413" r="71160" b="54695"/>
                <a:stretch/>
              </p:blipFill>
              <p:spPr>
                <a:xfrm>
                  <a:off x="1026306" y="6387629"/>
                  <a:ext cx="423747" cy="260809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pic>
              <p:nvPicPr>
                <p:cNvPr id="55" name="Picture 54">
                  <a:extLst>
                    <a:ext uri="{FF2B5EF4-FFF2-40B4-BE49-F238E27FC236}">
                      <a16:creationId xmlns:a16="http://schemas.microsoft.com/office/drawing/2014/main" id="{85A47694-96CC-DC83-889E-BF4E8116AE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8910" t="52311" r="69106" b="39013"/>
                <a:stretch/>
              </p:blipFill>
              <p:spPr>
                <a:xfrm>
                  <a:off x="1026307" y="6655897"/>
                  <a:ext cx="423746" cy="228742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D34C3FE2-4E1D-838C-E772-3A397B0C4758}"/>
                    </a:ext>
                  </a:extLst>
                </p:cNvPr>
                <p:cNvSpPr txBox="1"/>
                <p:nvPr/>
              </p:nvSpPr>
              <p:spPr>
                <a:xfrm>
                  <a:off x="672710" y="6377657"/>
                  <a:ext cx="4187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BRG1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B96AB539-80CC-23E6-16D1-CA8EE4D64AFD}"/>
                    </a:ext>
                  </a:extLst>
                </p:cNvPr>
                <p:cNvSpPr txBox="1"/>
                <p:nvPr/>
              </p:nvSpPr>
              <p:spPr>
                <a:xfrm>
                  <a:off x="672710" y="6662469"/>
                  <a:ext cx="4187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DHA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CD706B47-6CFD-BC53-C8E2-D46B93FFBA5E}"/>
                    </a:ext>
                  </a:extLst>
                </p:cNvPr>
                <p:cNvSpPr txBox="1"/>
                <p:nvPr/>
              </p:nvSpPr>
              <p:spPr>
                <a:xfrm>
                  <a:off x="579735" y="4942811"/>
                  <a:ext cx="51168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BAF60C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3B442653-C1DD-31F0-E8CB-1AC5A4B3C006}"/>
                    </a:ext>
                  </a:extLst>
                </p:cNvPr>
                <p:cNvSpPr txBox="1"/>
                <p:nvPr/>
              </p:nvSpPr>
              <p:spPr>
                <a:xfrm>
                  <a:off x="658283" y="5152850"/>
                  <a:ext cx="43313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tubulin</a:t>
                  </a:r>
                </a:p>
              </p:txBody>
            </p:sp>
            <p:pic>
              <p:nvPicPr>
                <p:cNvPr id="60" name="Picture 59">
                  <a:extLst>
                    <a:ext uri="{FF2B5EF4-FFF2-40B4-BE49-F238E27FC236}">
                      <a16:creationId xmlns:a16="http://schemas.microsoft.com/office/drawing/2014/main" id="{86222362-84EA-81B3-E58B-52BBE427945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32317" t="39769" r="49705" b="46149"/>
                <a:stretch/>
              </p:blipFill>
              <p:spPr>
                <a:xfrm>
                  <a:off x="1026305" y="4494907"/>
                  <a:ext cx="423747" cy="247522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pic>
              <p:nvPicPr>
                <p:cNvPr id="61" name="Picture 60">
                  <a:extLst>
                    <a:ext uri="{FF2B5EF4-FFF2-40B4-BE49-F238E27FC236}">
                      <a16:creationId xmlns:a16="http://schemas.microsoft.com/office/drawing/2014/main" id="{6D694DBE-E889-7AA2-4228-F7C88F677D9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30578" t="29369" r="51444" b="59500"/>
                <a:stretch/>
              </p:blipFill>
              <p:spPr>
                <a:xfrm>
                  <a:off x="1026304" y="4759414"/>
                  <a:ext cx="423747" cy="195645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F8A3B1F7-BA69-9044-9320-640AEA223EE5}"/>
                    </a:ext>
                  </a:extLst>
                </p:cNvPr>
                <p:cNvSpPr txBox="1"/>
                <p:nvPr/>
              </p:nvSpPr>
              <p:spPr>
                <a:xfrm>
                  <a:off x="650268" y="4514626"/>
                  <a:ext cx="4411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BAF47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91F5739D-AEA1-67C3-7601-99B526B47868}"/>
                    </a:ext>
                  </a:extLst>
                </p:cNvPr>
                <p:cNvSpPr txBox="1"/>
                <p:nvPr/>
              </p:nvSpPr>
              <p:spPr>
                <a:xfrm>
                  <a:off x="728815" y="4742429"/>
                  <a:ext cx="3626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8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ctin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14787132-0227-142F-12E5-C7DDA0F08D7F}"/>
                    </a:ext>
                  </a:extLst>
                </p:cNvPr>
                <p:cNvSpPr txBox="1"/>
                <p:nvPr/>
              </p:nvSpPr>
              <p:spPr>
                <a:xfrm rot="19220584">
                  <a:off x="946525" y="4229441"/>
                  <a:ext cx="5245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i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cramble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D03CB242-58EC-6C72-86A3-402AB450AA87}"/>
                    </a:ext>
                  </a:extLst>
                </p:cNvPr>
                <p:cNvSpPr txBox="1"/>
                <p:nvPr/>
              </p:nvSpPr>
              <p:spPr>
                <a:xfrm rot="19220584">
                  <a:off x="1179155" y="4250191"/>
                  <a:ext cx="46198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i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iAifm1</a:t>
                  </a:r>
                </a:p>
              </p:txBody>
            </p:sp>
          </p:grpSp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1B4623DF-186A-3079-AAB9-376056A219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4258" t="32152" r="63756" b="59784"/>
              <a:stretch/>
            </p:blipFill>
            <p:spPr>
              <a:xfrm>
                <a:off x="700785" y="5188347"/>
                <a:ext cx="423747" cy="21263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543DEFDD-1910-F668-CF28-E7273B8018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2523" t="55472" r="65079" b="36996"/>
              <a:stretch/>
            </p:blipFill>
            <p:spPr>
              <a:xfrm>
                <a:off x="700785" y="5415562"/>
                <a:ext cx="423747" cy="191955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E5345D2D-D345-4D45-1602-922E01D4DF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63348" t="55378" r="24095" b="36601"/>
            <a:stretch/>
          </p:blipFill>
          <p:spPr>
            <a:xfrm>
              <a:off x="815484" y="4956176"/>
              <a:ext cx="423313" cy="201635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12AC7737-6826-DF2E-8D40-D88CC25058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1072" t="32394" r="25744" b="54728"/>
            <a:stretch/>
          </p:blipFill>
          <p:spPr>
            <a:xfrm>
              <a:off x="815050" y="5173512"/>
              <a:ext cx="423747" cy="30864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87388D24-F085-4056-ADD3-BCB723C70D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9193" t="37339" r="77876" b="54269"/>
            <a:stretch/>
          </p:blipFill>
          <p:spPr>
            <a:xfrm>
              <a:off x="815049" y="4508549"/>
              <a:ext cx="423748" cy="20506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BBBB1915-9154-1E32-32C3-5B5A4214A8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163" t="52311" r="80853" b="39517"/>
            <a:stretch/>
          </p:blipFill>
          <p:spPr>
            <a:xfrm>
              <a:off x="815049" y="4725028"/>
              <a:ext cx="423748" cy="21544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6C56FC66-E5B1-704C-B3B7-D15DA02AD60D}"/>
              </a:ext>
            </a:extLst>
          </p:cNvPr>
          <p:cNvGrpSpPr/>
          <p:nvPr/>
        </p:nvGrpSpPr>
        <p:grpSpPr>
          <a:xfrm>
            <a:off x="1685262" y="654249"/>
            <a:ext cx="1833300" cy="1098550"/>
            <a:chOff x="2869880" y="3116307"/>
            <a:chExt cx="1833300" cy="1098550"/>
          </a:xfrm>
        </p:grpSpPr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2165BFF0-A0BA-A068-2B80-73EBFB66F2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229980" y="3116307"/>
              <a:ext cx="1473200" cy="1098550"/>
            </a:xfrm>
            <a:prstGeom prst="rect">
              <a:avLst/>
            </a:prstGeom>
          </p:spPr>
        </p:pic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6A38CB66-A6F0-93B2-AE0A-FF283D122895}"/>
                </a:ext>
              </a:extLst>
            </p:cNvPr>
            <p:cNvSpPr txBox="1"/>
            <p:nvPr/>
          </p:nvSpPr>
          <p:spPr>
            <a:xfrm rot="19358159">
              <a:off x="3639784" y="3360077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A5F22EA2-CFFC-DA86-ADE6-56776832D3A8}"/>
                </a:ext>
              </a:extLst>
            </p:cNvPr>
            <p:cNvSpPr txBox="1"/>
            <p:nvPr/>
          </p:nvSpPr>
          <p:spPr>
            <a:xfrm rot="19358159">
              <a:off x="3753511" y="3389441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C57D5431-2042-A3F7-674B-1C3540CF52E8}"/>
                </a:ext>
              </a:extLst>
            </p:cNvPr>
            <p:cNvSpPr/>
            <p:nvPr/>
          </p:nvSpPr>
          <p:spPr>
            <a:xfrm>
              <a:off x="3693924" y="3588190"/>
              <a:ext cx="274826" cy="98411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E01650BD-C2A8-1E4F-86A2-3C5FE926E19C}"/>
                </a:ext>
              </a:extLst>
            </p:cNvPr>
            <p:cNvSpPr txBox="1"/>
            <p:nvPr/>
          </p:nvSpPr>
          <p:spPr>
            <a:xfrm>
              <a:off x="4137491" y="3724539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BAF47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2EAD265-4F94-54F5-C2A8-6B7A904E722A}"/>
                </a:ext>
              </a:extLst>
            </p:cNvPr>
            <p:cNvSpPr txBox="1"/>
            <p:nvPr/>
          </p:nvSpPr>
          <p:spPr>
            <a:xfrm>
              <a:off x="2869880" y="346953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952BFAD6-D0E6-247C-3EB5-D34D1CFDDB5E}"/>
                </a:ext>
              </a:extLst>
            </p:cNvPr>
            <p:cNvSpPr txBox="1"/>
            <p:nvPr/>
          </p:nvSpPr>
          <p:spPr>
            <a:xfrm>
              <a:off x="2869880" y="361218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F5CFA7CF-360A-5E49-FA9E-3E80AE0CAB29}"/>
                </a:ext>
              </a:extLst>
            </p:cNvPr>
            <p:cNvSpPr txBox="1"/>
            <p:nvPr/>
          </p:nvSpPr>
          <p:spPr>
            <a:xfrm>
              <a:off x="2869880" y="372961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19517BCF-9918-5B6F-DCC0-700E4811FD9B}"/>
              </a:ext>
            </a:extLst>
          </p:cNvPr>
          <p:cNvGrpSpPr/>
          <p:nvPr/>
        </p:nvGrpSpPr>
        <p:grpSpPr>
          <a:xfrm>
            <a:off x="1683619" y="1790933"/>
            <a:ext cx="1835567" cy="1098550"/>
            <a:chOff x="2898217" y="4284521"/>
            <a:chExt cx="1835567" cy="1098550"/>
          </a:xfrm>
        </p:grpSpPr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14876D90-1ACF-7EA0-9F86-BB0A547854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260584" y="4284521"/>
              <a:ext cx="1473200" cy="1098550"/>
            </a:xfrm>
            <a:prstGeom prst="rect">
              <a:avLst/>
            </a:prstGeom>
          </p:spPr>
        </p:pic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BF22209-1008-B5B7-AAE2-DE40F976E5AC}"/>
                </a:ext>
              </a:extLst>
            </p:cNvPr>
            <p:cNvSpPr txBox="1"/>
            <p:nvPr/>
          </p:nvSpPr>
          <p:spPr>
            <a:xfrm rot="19358159">
              <a:off x="3646480" y="4400246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A30A43E7-5720-901B-2416-16FE7EC7AD94}"/>
                </a:ext>
              </a:extLst>
            </p:cNvPr>
            <p:cNvSpPr txBox="1"/>
            <p:nvPr/>
          </p:nvSpPr>
          <p:spPr>
            <a:xfrm rot="19358159">
              <a:off x="3760207" y="4429610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3C3057C1-961B-31DD-4C75-0B7491FF3739}"/>
                </a:ext>
              </a:extLst>
            </p:cNvPr>
            <p:cNvSpPr/>
            <p:nvPr/>
          </p:nvSpPr>
          <p:spPr>
            <a:xfrm>
              <a:off x="3706624" y="4626751"/>
              <a:ext cx="274826" cy="98411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4E0773BB-665A-92BC-1EE1-F1E9FCB01FA3}"/>
                </a:ext>
              </a:extLst>
            </p:cNvPr>
            <p:cNvSpPr txBox="1"/>
            <p:nvPr/>
          </p:nvSpPr>
          <p:spPr>
            <a:xfrm>
              <a:off x="4210516" y="4750027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AD8E315F-03A4-B378-E800-30D016F6E7F6}"/>
                </a:ext>
              </a:extLst>
            </p:cNvPr>
            <p:cNvSpPr txBox="1"/>
            <p:nvPr/>
          </p:nvSpPr>
          <p:spPr>
            <a:xfrm>
              <a:off x="2898217" y="448776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15A283AF-4869-49B1-53A9-B601A52ECF5E}"/>
                </a:ext>
              </a:extLst>
            </p:cNvPr>
            <p:cNvSpPr txBox="1"/>
            <p:nvPr/>
          </p:nvSpPr>
          <p:spPr>
            <a:xfrm>
              <a:off x="2898217" y="463041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687A4E5C-277F-BC06-D765-D712B8B4FB9E}"/>
                </a:ext>
              </a:extLst>
            </p:cNvPr>
            <p:cNvSpPr txBox="1"/>
            <p:nvPr/>
          </p:nvSpPr>
          <p:spPr>
            <a:xfrm>
              <a:off x="2898217" y="474783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633FE1BD-C4BE-1A9C-D01D-AA0500634EE9}"/>
              </a:ext>
            </a:extLst>
          </p:cNvPr>
          <p:cNvGrpSpPr/>
          <p:nvPr/>
        </p:nvGrpSpPr>
        <p:grpSpPr>
          <a:xfrm>
            <a:off x="3581984" y="664008"/>
            <a:ext cx="1829130" cy="1098550"/>
            <a:chOff x="4766602" y="3126066"/>
            <a:chExt cx="1829130" cy="1098550"/>
          </a:xfrm>
        </p:grpSpPr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id="{69E035A6-00D0-BF7C-D708-70D8F59C56D4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122532" y="3126066"/>
              <a:ext cx="1473200" cy="1098550"/>
            </a:xfrm>
            <a:prstGeom prst="rect">
              <a:avLst/>
            </a:prstGeom>
          </p:spPr>
        </p:pic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5EB9B245-6E96-9F36-3F1F-418D20766FCC}"/>
                </a:ext>
              </a:extLst>
            </p:cNvPr>
            <p:cNvSpPr txBox="1"/>
            <p:nvPr/>
          </p:nvSpPr>
          <p:spPr>
            <a:xfrm>
              <a:off x="4766602" y="341319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0EB79D6D-AAD2-7C1B-E47C-71F41E39C638}"/>
                </a:ext>
              </a:extLst>
            </p:cNvPr>
            <p:cNvSpPr txBox="1"/>
            <p:nvPr/>
          </p:nvSpPr>
          <p:spPr>
            <a:xfrm>
              <a:off x="4766602" y="355584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11DA78C8-94D6-24AF-C099-A5EC0382C04D}"/>
                </a:ext>
              </a:extLst>
            </p:cNvPr>
            <p:cNvSpPr txBox="1"/>
            <p:nvPr/>
          </p:nvSpPr>
          <p:spPr>
            <a:xfrm>
              <a:off x="4766602" y="367327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D83C0D9F-ECD1-396A-0266-139548B1636D}"/>
                </a:ext>
              </a:extLst>
            </p:cNvPr>
            <p:cNvSpPr/>
            <p:nvPr/>
          </p:nvSpPr>
          <p:spPr>
            <a:xfrm>
              <a:off x="5483225" y="3471712"/>
              <a:ext cx="174626" cy="98411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138E573B-0F0E-1582-6D56-85090D5DB574}"/>
                </a:ext>
              </a:extLst>
            </p:cNvPr>
            <p:cNvSpPr txBox="1"/>
            <p:nvPr/>
          </p:nvSpPr>
          <p:spPr>
            <a:xfrm rot="19358159">
              <a:off x="5373720" y="3244061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5DD2E639-C568-3A66-78FF-10A4E58E32C1}"/>
                </a:ext>
              </a:extLst>
            </p:cNvPr>
            <p:cNvSpPr txBox="1"/>
            <p:nvPr/>
          </p:nvSpPr>
          <p:spPr>
            <a:xfrm rot="19358159">
              <a:off x="5487447" y="3273425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0AF5F992-EDC3-1239-D5E0-88EF34F20E9F}"/>
                </a:ext>
              </a:extLst>
            </p:cNvPr>
            <p:cNvSpPr txBox="1"/>
            <p:nvPr/>
          </p:nvSpPr>
          <p:spPr>
            <a:xfrm>
              <a:off x="5971236" y="3673271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BAF60C</a:t>
              </a:r>
            </a:p>
          </p:txBody>
        </p:sp>
      </p:grp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AA6B3927-3AC6-17F2-37A9-FAF086E7A56B}"/>
              </a:ext>
            </a:extLst>
          </p:cNvPr>
          <p:cNvGrpSpPr/>
          <p:nvPr/>
        </p:nvGrpSpPr>
        <p:grpSpPr>
          <a:xfrm>
            <a:off x="3573898" y="1790728"/>
            <a:ext cx="1837216" cy="1098550"/>
            <a:chOff x="4758516" y="4284316"/>
            <a:chExt cx="1837216" cy="1098550"/>
          </a:xfrm>
        </p:grpSpPr>
        <p:pic>
          <p:nvPicPr>
            <p:cNvPr id="156" name="Picture 155">
              <a:extLst>
                <a:ext uri="{FF2B5EF4-FFF2-40B4-BE49-F238E27FC236}">
                  <a16:creationId xmlns:a16="http://schemas.microsoft.com/office/drawing/2014/main" id="{94313C11-2039-D7CB-8824-0539B8EA35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122532" y="4284316"/>
              <a:ext cx="1473200" cy="1098550"/>
            </a:xfrm>
            <a:prstGeom prst="rect">
              <a:avLst/>
            </a:prstGeom>
          </p:spPr>
        </p:pic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1C3A27E4-5090-7E87-0D15-7CC6E2D65964}"/>
                </a:ext>
              </a:extLst>
            </p:cNvPr>
            <p:cNvSpPr txBox="1"/>
            <p:nvPr/>
          </p:nvSpPr>
          <p:spPr>
            <a:xfrm>
              <a:off x="4758516" y="472775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55C22D1A-9D23-8AF8-EA80-BFAE3145B7BD}"/>
                </a:ext>
              </a:extLst>
            </p:cNvPr>
            <p:cNvSpPr txBox="1"/>
            <p:nvPr/>
          </p:nvSpPr>
          <p:spPr>
            <a:xfrm>
              <a:off x="4758516" y="487040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96DFE2EF-9671-856E-5F07-95C162A928AE}"/>
                </a:ext>
              </a:extLst>
            </p:cNvPr>
            <p:cNvSpPr txBox="1"/>
            <p:nvPr/>
          </p:nvSpPr>
          <p:spPr>
            <a:xfrm>
              <a:off x="4758516" y="498783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A96393EF-B173-C9AA-984B-4674A9C467C4}"/>
                </a:ext>
              </a:extLst>
            </p:cNvPr>
            <p:cNvSpPr/>
            <p:nvPr/>
          </p:nvSpPr>
          <p:spPr>
            <a:xfrm>
              <a:off x="5454650" y="4800417"/>
              <a:ext cx="174626" cy="98411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7B95EC6A-ECD1-A6A5-D1C1-A2D7A3BAF2B3}"/>
                </a:ext>
              </a:extLst>
            </p:cNvPr>
            <p:cNvSpPr txBox="1"/>
            <p:nvPr/>
          </p:nvSpPr>
          <p:spPr>
            <a:xfrm rot="19358159">
              <a:off x="5354669" y="4563628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8C32437-5F05-3708-87AD-CEC96DEA96E5}"/>
                </a:ext>
              </a:extLst>
            </p:cNvPr>
            <p:cNvSpPr txBox="1"/>
            <p:nvPr/>
          </p:nvSpPr>
          <p:spPr>
            <a:xfrm rot="19358159">
              <a:off x="5468396" y="4592992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7B3766FA-E403-FDA4-8278-7BC6958F89B8}"/>
                </a:ext>
              </a:extLst>
            </p:cNvPr>
            <p:cNvSpPr txBox="1"/>
            <p:nvPr/>
          </p:nvSpPr>
          <p:spPr>
            <a:xfrm>
              <a:off x="5963123" y="4982375"/>
              <a:ext cx="4331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tubulin</a:t>
              </a:r>
            </a:p>
          </p:txBody>
        </p:sp>
      </p:grpSp>
      <p:grpSp>
        <p:nvGrpSpPr>
          <p:cNvPr id="164" name="Group 163">
            <a:extLst>
              <a:ext uri="{FF2B5EF4-FFF2-40B4-BE49-F238E27FC236}">
                <a16:creationId xmlns:a16="http://schemas.microsoft.com/office/drawing/2014/main" id="{23116D9A-0F2F-0A88-9F0F-CA9DC7ECDAA3}"/>
              </a:ext>
            </a:extLst>
          </p:cNvPr>
          <p:cNvGrpSpPr/>
          <p:nvPr/>
        </p:nvGrpSpPr>
        <p:grpSpPr>
          <a:xfrm>
            <a:off x="1652606" y="3013549"/>
            <a:ext cx="1873276" cy="1098550"/>
            <a:chOff x="2837224" y="5254897"/>
            <a:chExt cx="1873276" cy="1098550"/>
          </a:xfrm>
        </p:grpSpPr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C1527134-28C1-4247-825E-1F4D742BC3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237300" y="5254897"/>
              <a:ext cx="1473200" cy="1098550"/>
            </a:xfrm>
            <a:prstGeom prst="rect">
              <a:avLst/>
            </a:prstGeom>
          </p:spPr>
        </p:pic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44CC6D49-4622-54B8-C8F0-C88DE57BB782}"/>
                </a:ext>
              </a:extLst>
            </p:cNvPr>
            <p:cNvSpPr txBox="1"/>
            <p:nvPr/>
          </p:nvSpPr>
          <p:spPr>
            <a:xfrm>
              <a:off x="2837224" y="5508052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50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47E3BED1-265C-5B78-FD03-1B443FB52C8E}"/>
                </a:ext>
              </a:extLst>
            </p:cNvPr>
            <p:cNvSpPr txBox="1"/>
            <p:nvPr/>
          </p:nvSpPr>
          <p:spPr>
            <a:xfrm>
              <a:off x="2837224" y="5641174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30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D2A34255-F47C-7BAE-9AC8-5636B753D044}"/>
                </a:ext>
              </a:extLst>
            </p:cNvPr>
            <p:cNvSpPr txBox="1"/>
            <p:nvPr/>
          </p:nvSpPr>
          <p:spPr>
            <a:xfrm>
              <a:off x="2883712" y="5749077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9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7E965F98-6899-DB41-5160-80D216B3EFEB}"/>
                </a:ext>
              </a:extLst>
            </p:cNvPr>
            <p:cNvSpPr/>
            <p:nvPr/>
          </p:nvSpPr>
          <p:spPr>
            <a:xfrm>
              <a:off x="3380964" y="5672710"/>
              <a:ext cx="187736" cy="76367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2F866B61-5BDB-02E2-EB67-7C990609BAB0}"/>
                </a:ext>
              </a:extLst>
            </p:cNvPr>
            <p:cNvSpPr txBox="1"/>
            <p:nvPr/>
          </p:nvSpPr>
          <p:spPr>
            <a:xfrm rot="19358159">
              <a:off x="3265338" y="542371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2F9721DA-2EEA-5882-8AFF-D630718ECCA2}"/>
                </a:ext>
              </a:extLst>
            </p:cNvPr>
            <p:cNvSpPr txBox="1"/>
            <p:nvPr/>
          </p:nvSpPr>
          <p:spPr>
            <a:xfrm rot="19358159">
              <a:off x="3379065" y="5453077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5A09A7CF-7066-4D45-FEE6-BA889B2FD69A}"/>
                </a:ext>
              </a:extLst>
            </p:cNvPr>
            <p:cNvSpPr txBox="1"/>
            <p:nvPr/>
          </p:nvSpPr>
          <p:spPr>
            <a:xfrm>
              <a:off x="4164619" y="5907917"/>
              <a:ext cx="4876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BAF170</a:t>
              </a:r>
            </a:p>
          </p:txBody>
        </p:sp>
      </p:grp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AFF94597-89BE-A28C-2907-F66F6C232893}"/>
              </a:ext>
            </a:extLst>
          </p:cNvPr>
          <p:cNvGrpSpPr/>
          <p:nvPr/>
        </p:nvGrpSpPr>
        <p:grpSpPr>
          <a:xfrm>
            <a:off x="1805275" y="4144352"/>
            <a:ext cx="1720607" cy="1098550"/>
            <a:chOff x="2989893" y="6385700"/>
            <a:chExt cx="1720607" cy="1098550"/>
          </a:xfrm>
        </p:grpSpPr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66968084-7727-EC44-1835-FCC9A0861A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237300" y="6385700"/>
              <a:ext cx="1473200" cy="1098550"/>
            </a:xfrm>
            <a:prstGeom prst="rect">
              <a:avLst/>
            </a:prstGeom>
          </p:spPr>
        </p:pic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455F2558-A405-87CC-0165-59B2942DCD43}"/>
                </a:ext>
              </a:extLst>
            </p:cNvPr>
            <p:cNvSpPr/>
            <p:nvPr/>
          </p:nvSpPr>
          <p:spPr>
            <a:xfrm>
              <a:off x="3434283" y="6887266"/>
              <a:ext cx="187736" cy="76367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9FA39EC2-1FA8-EDF9-BA90-8AFB60E5972A}"/>
                </a:ext>
              </a:extLst>
            </p:cNvPr>
            <p:cNvSpPr txBox="1"/>
            <p:nvPr/>
          </p:nvSpPr>
          <p:spPr>
            <a:xfrm>
              <a:off x="2989893" y="671632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9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7B66A07B-A4D3-0A59-345D-5CB27277F0C9}"/>
                </a:ext>
              </a:extLst>
            </p:cNvPr>
            <p:cNvSpPr txBox="1"/>
            <p:nvPr/>
          </p:nvSpPr>
          <p:spPr>
            <a:xfrm>
              <a:off x="2989893" y="6808167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BD381DA1-B9D0-9E42-EA5E-414AB6DF0CF8}"/>
                </a:ext>
              </a:extLst>
            </p:cNvPr>
            <p:cNvSpPr txBox="1"/>
            <p:nvPr/>
          </p:nvSpPr>
          <p:spPr>
            <a:xfrm>
              <a:off x="2989893" y="689702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81EC0899-C4F9-6FE1-7DA1-82C09A019EE8}"/>
                </a:ext>
              </a:extLst>
            </p:cNvPr>
            <p:cNvSpPr txBox="1"/>
            <p:nvPr/>
          </p:nvSpPr>
          <p:spPr>
            <a:xfrm rot="19358159">
              <a:off x="3337477" y="6654031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B4B98B16-321B-F600-AC81-068942256E07}"/>
                </a:ext>
              </a:extLst>
            </p:cNvPr>
            <p:cNvSpPr txBox="1"/>
            <p:nvPr/>
          </p:nvSpPr>
          <p:spPr>
            <a:xfrm rot="19358159">
              <a:off x="3451204" y="6683395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30E7EBB7-71AD-9984-CD56-B630F9BC6DC8}"/>
                </a:ext>
              </a:extLst>
            </p:cNvPr>
            <p:cNvSpPr txBox="1"/>
            <p:nvPr/>
          </p:nvSpPr>
          <p:spPr>
            <a:xfrm>
              <a:off x="4149838" y="6808167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DHA</a:t>
              </a:r>
            </a:p>
          </p:txBody>
        </p:sp>
      </p:grpSp>
      <p:grpSp>
        <p:nvGrpSpPr>
          <p:cNvPr id="182" name="Group 181">
            <a:extLst>
              <a:ext uri="{FF2B5EF4-FFF2-40B4-BE49-F238E27FC236}">
                <a16:creationId xmlns:a16="http://schemas.microsoft.com/office/drawing/2014/main" id="{0D630FAA-1690-FF37-99FF-806F971F18DF}"/>
              </a:ext>
            </a:extLst>
          </p:cNvPr>
          <p:cNvGrpSpPr/>
          <p:nvPr/>
        </p:nvGrpSpPr>
        <p:grpSpPr>
          <a:xfrm>
            <a:off x="3949184" y="3013549"/>
            <a:ext cx="1473200" cy="1098550"/>
            <a:chOff x="5133802" y="5254897"/>
            <a:chExt cx="1473200" cy="1098550"/>
          </a:xfrm>
        </p:grpSpPr>
        <p:pic>
          <p:nvPicPr>
            <p:cNvPr id="183" name="Picture 182">
              <a:extLst>
                <a:ext uri="{FF2B5EF4-FFF2-40B4-BE49-F238E27FC236}">
                  <a16:creationId xmlns:a16="http://schemas.microsoft.com/office/drawing/2014/main" id="{79121C7E-394D-6D00-BB9A-20B78A0BB8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133802" y="5254897"/>
              <a:ext cx="1473200" cy="1098550"/>
            </a:xfrm>
            <a:prstGeom prst="rect">
              <a:avLst/>
            </a:prstGeom>
          </p:spPr>
        </p:pic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6ECDD18F-2505-22E2-34F3-4D754421C214}"/>
                </a:ext>
              </a:extLst>
            </p:cNvPr>
            <p:cNvSpPr txBox="1"/>
            <p:nvPr/>
          </p:nvSpPr>
          <p:spPr>
            <a:xfrm>
              <a:off x="5133802" y="5659531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250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1AC8D08-3E4A-797A-2D7A-7FBA42C152D4}"/>
                </a:ext>
              </a:extLst>
            </p:cNvPr>
            <p:cNvSpPr txBox="1"/>
            <p:nvPr/>
          </p:nvSpPr>
          <p:spPr>
            <a:xfrm>
              <a:off x="5133802" y="5851041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130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DCE9D042-62FF-A038-2F1B-E9A737832AB5}"/>
                </a:ext>
              </a:extLst>
            </p:cNvPr>
            <p:cNvSpPr txBox="1"/>
            <p:nvPr/>
          </p:nvSpPr>
          <p:spPr>
            <a:xfrm rot="19358159">
              <a:off x="5949668" y="5635534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9F2A0A62-ED13-9ACA-4FCA-BB078500308B}"/>
                </a:ext>
              </a:extLst>
            </p:cNvPr>
            <p:cNvSpPr txBox="1"/>
            <p:nvPr/>
          </p:nvSpPr>
          <p:spPr>
            <a:xfrm rot="19358159">
              <a:off x="6063395" y="5664898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96345696-C819-A016-8293-921589983D52}"/>
                </a:ext>
              </a:extLst>
            </p:cNvPr>
            <p:cNvSpPr/>
            <p:nvPr/>
          </p:nvSpPr>
          <p:spPr>
            <a:xfrm>
              <a:off x="6065116" y="5874975"/>
              <a:ext cx="187136" cy="98936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A4CCC04-DFAF-8FB7-7976-A2A02E38D728}"/>
                </a:ext>
              </a:extLst>
            </p:cNvPr>
            <p:cNvSpPr txBox="1"/>
            <p:nvPr/>
          </p:nvSpPr>
          <p:spPr>
            <a:xfrm>
              <a:off x="5544481" y="5459652"/>
              <a:ext cx="3722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BRM</a:t>
              </a:r>
            </a:p>
          </p:txBody>
        </p:sp>
      </p:grp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BD480D18-32E6-AC3A-A428-70FFEC7CD679}"/>
              </a:ext>
            </a:extLst>
          </p:cNvPr>
          <p:cNvGrpSpPr/>
          <p:nvPr/>
        </p:nvGrpSpPr>
        <p:grpSpPr>
          <a:xfrm>
            <a:off x="3949184" y="4144352"/>
            <a:ext cx="1473200" cy="1098550"/>
            <a:chOff x="5133802" y="6385700"/>
            <a:chExt cx="1473200" cy="1098550"/>
          </a:xfrm>
        </p:grpSpPr>
        <p:pic>
          <p:nvPicPr>
            <p:cNvPr id="191" name="Picture 190">
              <a:extLst>
                <a:ext uri="{FF2B5EF4-FFF2-40B4-BE49-F238E27FC236}">
                  <a16:creationId xmlns:a16="http://schemas.microsoft.com/office/drawing/2014/main" id="{DB85D854-B633-5157-67D5-9ED0AAEC92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133802" y="6385700"/>
              <a:ext cx="1473200" cy="1098550"/>
            </a:xfrm>
            <a:prstGeom prst="rect">
              <a:avLst/>
            </a:prstGeom>
          </p:spPr>
        </p:pic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D3A1463A-DA45-C68C-6171-911CA2C968D1}"/>
                </a:ext>
              </a:extLst>
            </p:cNvPr>
            <p:cNvSpPr txBox="1"/>
            <p:nvPr/>
          </p:nvSpPr>
          <p:spPr>
            <a:xfrm>
              <a:off x="5141937" y="6458849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9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4B4830E9-E877-EB6C-19DD-2BC2BA0FD719}"/>
                </a:ext>
              </a:extLst>
            </p:cNvPr>
            <p:cNvSpPr txBox="1"/>
            <p:nvPr/>
          </p:nvSpPr>
          <p:spPr>
            <a:xfrm>
              <a:off x="5141937" y="657113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E07C012D-E6A6-0DA9-E80C-A782C9307091}"/>
                </a:ext>
              </a:extLst>
            </p:cNvPr>
            <p:cNvSpPr txBox="1"/>
            <p:nvPr/>
          </p:nvSpPr>
          <p:spPr>
            <a:xfrm>
              <a:off x="5141937" y="668846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F0F374E7-2CF1-A396-9160-807DDC6775CD}"/>
                </a:ext>
              </a:extLst>
            </p:cNvPr>
            <p:cNvSpPr txBox="1"/>
            <p:nvPr/>
          </p:nvSpPr>
          <p:spPr>
            <a:xfrm rot="19358159">
              <a:off x="5933713" y="6527766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BB1FC6BE-289B-966B-509E-25011DAFE68D}"/>
                </a:ext>
              </a:extLst>
            </p:cNvPr>
            <p:cNvSpPr txBox="1"/>
            <p:nvPr/>
          </p:nvSpPr>
          <p:spPr>
            <a:xfrm rot="19358159">
              <a:off x="6047440" y="6557130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197" name="Rectangle 196">
              <a:extLst>
                <a:ext uri="{FF2B5EF4-FFF2-40B4-BE49-F238E27FC236}">
                  <a16:creationId xmlns:a16="http://schemas.microsoft.com/office/drawing/2014/main" id="{F2685018-52B9-0E56-E055-4FD3031A575E}"/>
                </a:ext>
              </a:extLst>
            </p:cNvPr>
            <p:cNvSpPr/>
            <p:nvPr/>
          </p:nvSpPr>
          <p:spPr>
            <a:xfrm>
              <a:off x="6037119" y="6761281"/>
              <a:ext cx="187136" cy="98936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28CCC62C-F55F-16B8-ACC3-DD329408BD59}"/>
                </a:ext>
              </a:extLst>
            </p:cNvPr>
            <p:cNvSpPr txBox="1"/>
            <p:nvPr/>
          </p:nvSpPr>
          <p:spPr>
            <a:xfrm>
              <a:off x="5938666" y="6897843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ctin</a:t>
              </a:r>
            </a:p>
          </p:txBody>
        </p:sp>
      </p:grp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D529CB8C-1E3E-4EE9-795F-CF25932EBA4A}"/>
              </a:ext>
            </a:extLst>
          </p:cNvPr>
          <p:cNvGrpSpPr/>
          <p:nvPr/>
        </p:nvGrpSpPr>
        <p:grpSpPr>
          <a:xfrm>
            <a:off x="1786278" y="6431637"/>
            <a:ext cx="1739604" cy="1098550"/>
            <a:chOff x="2970896" y="8691839"/>
            <a:chExt cx="1739604" cy="1098550"/>
          </a:xfrm>
        </p:grpSpPr>
        <p:pic>
          <p:nvPicPr>
            <p:cNvPr id="200" name="Picture 199">
              <a:extLst>
                <a:ext uri="{FF2B5EF4-FFF2-40B4-BE49-F238E27FC236}">
                  <a16:creationId xmlns:a16="http://schemas.microsoft.com/office/drawing/2014/main" id="{66CBD328-96B1-F49F-E6E1-0D1C309A096C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237300" y="8691839"/>
              <a:ext cx="1473200" cy="1098550"/>
            </a:xfrm>
            <a:prstGeom prst="rect">
              <a:avLst/>
            </a:prstGeom>
          </p:spPr>
        </p:pic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E4EA06F3-CC94-12AC-177C-5D1B3ADD4829}"/>
                </a:ext>
              </a:extLst>
            </p:cNvPr>
            <p:cNvSpPr txBox="1"/>
            <p:nvPr/>
          </p:nvSpPr>
          <p:spPr>
            <a:xfrm rot="19358159">
              <a:off x="3495470" y="8969877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C3747ACB-2924-0507-3CC8-3C4E714EB483}"/>
                </a:ext>
              </a:extLst>
            </p:cNvPr>
            <p:cNvSpPr txBox="1"/>
            <p:nvPr/>
          </p:nvSpPr>
          <p:spPr>
            <a:xfrm rot="19358159">
              <a:off x="3609197" y="8999241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FEFBF2D1-CF12-A95F-FB0C-5ED607D1D2EA}"/>
                </a:ext>
              </a:extLst>
            </p:cNvPr>
            <p:cNvSpPr txBox="1"/>
            <p:nvPr/>
          </p:nvSpPr>
          <p:spPr>
            <a:xfrm>
              <a:off x="2970896" y="9023007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9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6956641A-2AC2-B058-33D3-F0E59DB09DB0}"/>
                </a:ext>
              </a:extLst>
            </p:cNvPr>
            <p:cNvSpPr txBox="1"/>
            <p:nvPr/>
          </p:nvSpPr>
          <p:spPr>
            <a:xfrm>
              <a:off x="2970896" y="9105329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7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2236D0AC-6649-363D-47C0-84C5D043A789}"/>
                </a:ext>
              </a:extLst>
            </p:cNvPr>
            <p:cNvSpPr txBox="1"/>
            <p:nvPr/>
          </p:nvSpPr>
          <p:spPr>
            <a:xfrm>
              <a:off x="2970896" y="9203707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06" name="Rectangle 205">
              <a:extLst>
                <a:ext uri="{FF2B5EF4-FFF2-40B4-BE49-F238E27FC236}">
                  <a16:creationId xmlns:a16="http://schemas.microsoft.com/office/drawing/2014/main" id="{A1F543B7-43D6-D456-92A5-F75FBC0E3651}"/>
                </a:ext>
              </a:extLst>
            </p:cNvPr>
            <p:cNvSpPr/>
            <p:nvPr/>
          </p:nvSpPr>
          <p:spPr>
            <a:xfrm>
              <a:off x="3602579" y="9190698"/>
              <a:ext cx="183669" cy="82322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248A9E2D-0BB7-2029-590E-050FCD0416BF}"/>
                </a:ext>
              </a:extLst>
            </p:cNvPr>
            <p:cNvSpPr txBox="1"/>
            <p:nvPr/>
          </p:nvSpPr>
          <p:spPr>
            <a:xfrm>
              <a:off x="4122406" y="9165298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>
                  <a:latin typeface="Arial Narrow" panose="020B0604020202020204" pitchFamily="34" charset="0"/>
                  <a:cs typeface="Arial Narrow" panose="020B0604020202020204" pitchFamily="34" charset="0"/>
                </a:rPr>
                <a:t>SDH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208" name="Group 207">
            <a:extLst>
              <a:ext uri="{FF2B5EF4-FFF2-40B4-BE49-F238E27FC236}">
                <a16:creationId xmlns:a16="http://schemas.microsoft.com/office/drawing/2014/main" id="{DB9A7987-33A8-CBD7-360B-D412A1B7987F}"/>
              </a:ext>
            </a:extLst>
          </p:cNvPr>
          <p:cNvGrpSpPr/>
          <p:nvPr/>
        </p:nvGrpSpPr>
        <p:grpSpPr>
          <a:xfrm>
            <a:off x="1644119" y="5306228"/>
            <a:ext cx="1881763" cy="1098550"/>
            <a:chOff x="2828737" y="7547576"/>
            <a:chExt cx="1881763" cy="1098550"/>
          </a:xfrm>
        </p:grpSpPr>
        <p:pic>
          <p:nvPicPr>
            <p:cNvPr id="209" name="Picture 208">
              <a:extLst>
                <a:ext uri="{FF2B5EF4-FFF2-40B4-BE49-F238E27FC236}">
                  <a16:creationId xmlns:a16="http://schemas.microsoft.com/office/drawing/2014/main" id="{ACF72426-B208-2876-3687-B0053F7E90DA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237300" y="7547576"/>
              <a:ext cx="1473200" cy="1098550"/>
            </a:xfrm>
            <a:prstGeom prst="rect">
              <a:avLst/>
            </a:prstGeom>
          </p:spPr>
        </p:pic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A2DA7620-7057-63FB-0F7F-0A7177704633}"/>
                </a:ext>
              </a:extLst>
            </p:cNvPr>
            <p:cNvSpPr txBox="1"/>
            <p:nvPr/>
          </p:nvSpPr>
          <p:spPr>
            <a:xfrm>
              <a:off x="2828737" y="7822627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50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1810AB9E-6849-BA67-3953-73A5FE780342}"/>
                </a:ext>
              </a:extLst>
            </p:cNvPr>
            <p:cNvSpPr txBox="1"/>
            <p:nvPr/>
          </p:nvSpPr>
          <p:spPr>
            <a:xfrm>
              <a:off x="2828737" y="7955749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30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8369478D-C2DF-65E0-4C9F-974418321C57}"/>
                </a:ext>
              </a:extLst>
            </p:cNvPr>
            <p:cNvSpPr txBox="1"/>
            <p:nvPr/>
          </p:nvSpPr>
          <p:spPr>
            <a:xfrm>
              <a:off x="2875225" y="8063652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95 </a:t>
              </a:r>
              <a:r>
                <a:rPr lang="en-GB" sz="800" dirty="0" err="1"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69A94D4A-D9DA-12B6-1903-4BFC54EE722F}"/>
                </a:ext>
              </a:extLst>
            </p:cNvPr>
            <p:cNvSpPr txBox="1"/>
            <p:nvPr/>
          </p:nvSpPr>
          <p:spPr>
            <a:xfrm rot="19358159">
              <a:off x="3383477" y="7725276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cramble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4F0885C4-5935-7932-D6A0-DE7C01191D34}"/>
                </a:ext>
              </a:extLst>
            </p:cNvPr>
            <p:cNvSpPr txBox="1"/>
            <p:nvPr/>
          </p:nvSpPr>
          <p:spPr>
            <a:xfrm rot="19358159">
              <a:off x="3497204" y="7754640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iAifm1</a:t>
              </a:r>
            </a:p>
          </p:txBody>
        </p:sp>
        <p:sp>
          <p:nvSpPr>
            <p:cNvPr id="215" name="Rectangle 214">
              <a:extLst>
                <a:ext uri="{FF2B5EF4-FFF2-40B4-BE49-F238E27FC236}">
                  <a16:creationId xmlns:a16="http://schemas.microsoft.com/office/drawing/2014/main" id="{62109555-DF9A-8C36-C716-0A31B80AE8E9}"/>
                </a:ext>
              </a:extLst>
            </p:cNvPr>
            <p:cNvSpPr/>
            <p:nvPr/>
          </p:nvSpPr>
          <p:spPr>
            <a:xfrm>
              <a:off x="3483456" y="7949399"/>
              <a:ext cx="183669" cy="82322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87A36EC2-30AA-45BD-8978-180866714856}"/>
                </a:ext>
              </a:extLst>
            </p:cNvPr>
            <p:cNvSpPr txBox="1"/>
            <p:nvPr/>
          </p:nvSpPr>
          <p:spPr>
            <a:xfrm>
              <a:off x="4051489" y="8210802"/>
              <a:ext cx="4138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BRG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364750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DD73037-2998-A442-9CCD-2686D458120F}"/>
              </a:ext>
            </a:extLst>
          </p:cNvPr>
          <p:cNvSpPr txBox="1"/>
          <p:nvPr/>
        </p:nvSpPr>
        <p:spPr>
          <a:xfrm>
            <a:off x="5452201" y="9595937"/>
            <a:ext cx="1388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Source data-WB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371870-8289-C25A-E5DA-F318C9BB1C22}"/>
              </a:ext>
            </a:extLst>
          </p:cNvPr>
          <p:cNvSpPr txBox="1"/>
          <p:nvPr/>
        </p:nvSpPr>
        <p:spPr>
          <a:xfrm>
            <a:off x="10190" y="14994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3A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42ADE6D-1FC1-C7F5-B046-61DBE5F177BB}"/>
              </a:ext>
            </a:extLst>
          </p:cNvPr>
          <p:cNvGrpSpPr/>
          <p:nvPr/>
        </p:nvGrpSpPr>
        <p:grpSpPr>
          <a:xfrm>
            <a:off x="119569" y="460722"/>
            <a:ext cx="1568673" cy="610038"/>
            <a:chOff x="1415492" y="6072541"/>
            <a:chExt cx="1568673" cy="61003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50D383AB-63FB-AA9E-6E5C-C679671B8E63}"/>
                </a:ext>
              </a:extLst>
            </p:cNvPr>
            <p:cNvGrpSpPr/>
            <p:nvPr/>
          </p:nvGrpSpPr>
          <p:grpSpPr>
            <a:xfrm>
              <a:off x="1415492" y="6072541"/>
              <a:ext cx="1129291" cy="610038"/>
              <a:chOff x="1661560" y="5965059"/>
              <a:chExt cx="1129291" cy="610038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DAA4236-2A18-5B7F-7926-1BC031B6D68F}"/>
                  </a:ext>
                </a:extLst>
              </p:cNvPr>
              <p:cNvSpPr txBox="1"/>
              <p:nvPr/>
            </p:nvSpPr>
            <p:spPr>
              <a:xfrm>
                <a:off x="1661560" y="6140144"/>
                <a:ext cx="5212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NDUFS4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492D91F-B6C1-E6EF-4907-14D5E9B85EE1}"/>
                  </a:ext>
                </a:extLst>
              </p:cNvPr>
              <p:cNvSpPr txBox="1"/>
              <p:nvPr/>
            </p:nvSpPr>
            <p:spPr>
              <a:xfrm>
                <a:off x="1746031" y="6352210"/>
                <a:ext cx="4331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tubulin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391078E-910F-890F-35A7-A92814078B85}"/>
                  </a:ext>
                </a:extLst>
              </p:cNvPr>
              <p:cNvSpPr txBox="1"/>
              <p:nvPr/>
            </p:nvSpPr>
            <p:spPr>
              <a:xfrm>
                <a:off x="2267582" y="5965059"/>
                <a:ext cx="260554" cy="1508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r>
                  <a:rPr lang="de-DE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C553CBD-D1B0-8A8D-4BA0-A30CF1BD537C}"/>
                  </a:ext>
                </a:extLst>
              </p:cNvPr>
              <p:cNvSpPr txBox="1"/>
              <p:nvPr/>
            </p:nvSpPr>
            <p:spPr>
              <a:xfrm>
                <a:off x="2140864" y="5965059"/>
                <a:ext cx="177518" cy="1508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4CA50E5-7D0E-C0BA-1425-7CA4EB7C920C}"/>
                  </a:ext>
                </a:extLst>
              </p:cNvPr>
              <p:cNvSpPr txBox="1"/>
              <p:nvPr/>
            </p:nvSpPr>
            <p:spPr>
              <a:xfrm>
                <a:off x="2498534" y="5965059"/>
                <a:ext cx="260554" cy="1508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r>
                  <a:rPr lang="de-DE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3BC31B96-1AFD-26DC-7115-16AB0F2410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9021" t="35783" r="32306" b="53081"/>
              <a:stretch/>
            </p:blipFill>
            <p:spPr>
              <a:xfrm>
                <a:off x="2114994" y="6147459"/>
                <a:ext cx="675857" cy="19573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99A91787-4CCE-8016-E3B0-AE008CC441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9096" t="32727" r="32231" b="54593"/>
              <a:stretch/>
            </p:blipFill>
            <p:spPr>
              <a:xfrm>
                <a:off x="2114994" y="6352210"/>
                <a:ext cx="675857" cy="222887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sp>
          <p:nvSpPr>
            <p:cNvPr id="6" name="Triangle 5">
              <a:extLst>
                <a:ext uri="{FF2B5EF4-FFF2-40B4-BE49-F238E27FC236}">
                  <a16:creationId xmlns:a16="http://schemas.microsoft.com/office/drawing/2014/main" id="{22A44C46-2900-AF29-F449-D42567BAF944}"/>
                </a:ext>
              </a:extLst>
            </p:cNvPr>
            <p:cNvSpPr/>
            <p:nvPr/>
          </p:nvSpPr>
          <p:spPr>
            <a:xfrm rot="16200000">
              <a:off x="2529764" y="6345519"/>
              <a:ext cx="45719" cy="7368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D16EC31-26D4-D264-9A18-67B26BA09B8B}"/>
                </a:ext>
              </a:extLst>
            </p:cNvPr>
            <p:cNvSpPr txBox="1"/>
            <p:nvPr/>
          </p:nvSpPr>
          <p:spPr>
            <a:xfrm>
              <a:off x="2515768" y="6280675"/>
              <a:ext cx="46839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unspecific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A6138122-74E4-B938-D83E-E41C5AD082CE}"/>
              </a:ext>
            </a:extLst>
          </p:cNvPr>
          <p:cNvGrpSpPr/>
          <p:nvPr/>
        </p:nvGrpSpPr>
        <p:grpSpPr>
          <a:xfrm>
            <a:off x="1773238" y="1784481"/>
            <a:ext cx="1473200" cy="1098550"/>
            <a:chOff x="3457879" y="4678775"/>
            <a:chExt cx="1473200" cy="109855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69B9504-68DC-223A-4391-B051E9C4B73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57879" y="4678775"/>
              <a:ext cx="1473200" cy="1098550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295CC828-4F76-F3FC-7192-CB46F1723EC3}"/>
                </a:ext>
              </a:extLst>
            </p:cNvPr>
            <p:cNvSpPr/>
            <p:nvPr/>
          </p:nvSpPr>
          <p:spPr>
            <a:xfrm>
              <a:off x="4056431" y="5021758"/>
              <a:ext cx="379043" cy="180132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05E9CE7-9620-F508-A7F7-F02B2C120076}"/>
                </a:ext>
              </a:extLst>
            </p:cNvPr>
            <p:cNvSpPr txBox="1"/>
            <p:nvPr/>
          </p:nvSpPr>
          <p:spPr>
            <a:xfrm>
              <a:off x="3525423" y="5130634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E93B8B1-8410-4F96-E15B-FAE6F5654E6B}"/>
                </a:ext>
              </a:extLst>
            </p:cNvPr>
            <p:cNvSpPr txBox="1"/>
            <p:nvPr/>
          </p:nvSpPr>
          <p:spPr>
            <a:xfrm>
              <a:off x="3503969" y="4983405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5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734A2EB-6CCC-3597-C28A-676FED4CC49D}"/>
                </a:ext>
              </a:extLst>
            </p:cNvPr>
            <p:cNvSpPr txBox="1"/>
            <p:nvPr/>
          </p:nvSpPr>
          <p:spPr>
            <a:xfrm>
              <a:off x="4086161" y="5317419"/>
              <a:ext cx="4331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tubuli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265F818-4415-FCD6-74FC-85154D5A76C0}"/>
                </a:ext>
              </a:extLst>
            </p:cNvPr>
            <p:cNvSpPr txBox="1"/>
            <p:nvPr/>
          </p:nvSpPr>
          <p:spPr>
            <a:xfrm>
              <a:off x="4001519" y="487031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P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64E5A85-99FE-55C9-17BA-802BB44748EC}"/>
                </a:ext>
              </a:extLst>
            </p:cNvPr>
            <p:cNvSpPr txBox="1"/>
            <p:nvPr/>
          </p:nvSpPr>
          <p:spPr>
            <a:xfrm>
              <a:off x="4087660" y="487031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KO</a:t>
              </a:r>
              <a:r>
                <a:rPr lang="en-GB" sz="700" baseline="-250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</a:t>
              </a:r>
              <a:endParaRPr lang="en-GB" sz="7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009D955-E003-4D75-48BF-D4224773D96D}"/>
                </a:ext>
              </a:extLst>
            </p:cNvPr>
            <p:cNvSpPr txBox="1"/>
            <p:nvPr/>
          </p:nvSpPr>
          <p:spPr>
            <a:xfrm>
              <a:off x="4238229" y="4866750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KO</a:t>
              </a:r>
              <a:r>
                <a:rPr lang="en-GB" sz="700" baseline="-250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</a:t>
              </a:r>
              <a:endParaRPr lang="en-GB" sz="7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BB4170F4-5488-9A61-4282-F93A042748FA}"/>
              </a:ext>
            </a:extLst>
          </p:cNvPr>
          <p:cNvGrpSpPr/>
          <p:nvPr/>
        </p:nvGrpSpPr>
        <p:grpSpPr>
          <a:xfrm>
            <a:off x="1773238" y="639039"/>
            <a:ext cx="1473200" cy="1098550"/>
            <a:chOff x="3457879" y="3533333"/>
            <a:chExt cx="1473200" cy="1098550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56E097EC-CE3E-49EC-C29B-D98943D5ACC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57879" y="3533333"/>
              <a:ext cx="1473200" cy="1098550"/>
            </a:xfrm>
            <a:prstGeom prst="rect">
              <a:avLst/>
            </a:prstGeom>
          </p:spPr>
        </p:pic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0591FC38-44DA-566C-CCED-0D2792833A30}"/>
                </a:ext>
              </a:extLst>
            </p:cNvPr>
            <p:cNvSpPr/>
            <p:nvPr/>
          </p:nvSpPr>
          <p:spPr>
            <a:xfrm>
              <a:off x="4056431" y="3905952"/>
              <a:ext cx="379043" cy="180132"/>
            </a:xfrm>
            <a:prstGeom prst="rect">
              <a:avLst/>
            </a:prstGeom>
            <a:noFill/>
            <a:ln w="31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292F967-42A1-91F5-4C1E-BCDBC4690572}"/>
                </a:ext>
              </a:extLst>
            </p:cNvPr>
            <p:cNvSpPr txBox="1"/>
            <p:nvPr/>
          </p:nvSpPr>
          <p:spPr>
            <a:xfrm>
              <a:off x="3525423" y="377395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28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23A7CB6-C788-3648-4A2E-F1668289DE18}"/>
                </a:ext>
              </a:extLst>
            </p:cNvPr>
            <p:cNvSpPr txBox="1"/>
            <p:nvPr/>
          </p:nvSpPr>
          <p:spPr>
            <a:xfrm>
              <a:off x="3525423" y="3897902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15 </a:t>
              </a:r>
              <a:r>
                <a:rPr lang="en-GB" sz="800" dirty="0" err="1">
                  <a:solidFill>
                    <a:schemeClr val="bg1"/>
                  </a:solidFill>
                  <a:latin typeface="Arial Narrow" panose="020B0604020202020204" pitchFamily="34" charset="0"/>
                  <a:cs typeface="Arial Narrow" panose="020B0604020202020204" pitchFamily="34" charset="0"/>
                </a:rPr>
                <a:t>kDa</a:t>
              </a:r>
              <a:endParaRPr lang="en-GB" sz="800" dirty="0">
                <a:solidFill>
                  <a:schemeClr val="bg1"/>
                </a:solidFill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B2D64E7-4A99-F8E7-61E1-7C3E16B23280}"/>
                </a:ext>
              </a:extLst>
            </p:cNvPr>
            <p:cNvSpPr txBox="1"/>
            <p:nvPr/>
          </p:nvSpPr>
          <p:spPr>
            <a:xfrm>
              <a:off x="4042079" y="4167688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NDUFS4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F4B81DE-0EB9-6399-C031-95BACB5E1E46}"/>
                </a:ext>
              </a:extLst>
            </p:cNvPr>
            <p:cNvSpPr txBox="1"/>
            <p:nvPr/>
          </p:nvSpPr>
          <p:spPr>
            <a:xfrm>
              <a:off x="4001365" y="374573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P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D89569F-7DBD-0584-7597-E78AC307A800}"/>
                </a:ext>
              </a:extLst>
            </p:cNvPr>
            <p:cNvSpPr txBox="1"/>
            <p:nvPr/>
          </p:nvSpPr>
          <p:spPr>
            <a:xfrm>
              <a:off x="4087506" y="3745737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KO</a:t>
              </a:r>
              <a:r>
                <a:rPr lang="en-GB" sz="700" baseline="-250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</a:t>
              </a:r>
              <a:endParaRPr lang="en-GB" sz="7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5CA2BDE-392A-17AE-CD6D-B5DCD00974D4}"/>
                </a:ext>
              </a:extLst>
            </p:cNvPr>
            <p:cNvSpPr txBox="1"/>
            <p:nvPr/>
          </p:nvSpPr>
          <p:spPr>
            <a:xfrm>
              <a:off x="4238075" y="3742168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KO</a:t>
              </a:r>
              <a:r>
                <a:rPr lang="en-GB" sz="700" baseline="-250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</a:t>
              </a:r>
              <a:endParaRPr lang="en-GB" sz="700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6500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0</TotalTime>
  <Words>389</Words>
  <Application>Microsoft Macintosh PowerPoint</Application>
  <PresentationFormat>A4 Paper (210x297 mm)</PresentationFormat>
  <Paragraphs>248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Arial Narrow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Daniele Bano</cp:lastModifiedBy>
  <cp:revision>40</cp:revision>
  <dcterms:created xsi:type="dcterms:W3CDTF">2024-03-04T14:34:49Z</dcterms:created>
  <dcterms:modified xsi:type="dcterms:W3CDTF">2024-06-10T15:22:18Z</dcterms:modified>
</cp:coreProperties>
</file>